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7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jpe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jpe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jpe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Text Box 76"/>
          <p:cNvSpPr txBox="1">
            <a:spLocks noChangeArrowheads="1"/>
          </p:cNvSpPr>
          <p:nvPr/>
        </p:nvSpPr>
        <p:spPr bwMode="auto">
          <a:xfrm>
            <a:off x="1524796" y="628469"/>
            <a:ext cx="49323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 smtClean="0">
                <a:solidFill>
                  <a:srgbClr val="008000"/>
                </a:solidFill>
                <a:latin typeface="Arial"/>
                <a:cs typeface="Arial"/>
              </a:rPr>
              <a:t>EGFP</a:t>
            </a:r>
            <a:endParaRPr lang="en-US" altLang="ja-JP" sz="9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77" name="Text Box 77"/>
          <p:cNvSpPr txBox="1">
            <a:spLocks noChangeArrowheads="1"/>
          </p:cNvSpPr>
          <p:nvPr/>
        </p:nvSpPr>
        <p:spPr bwMode="auto">
          <a:xfrm>
            <a:off x="2315199" y="628469"/>
            <a:ext cx="53348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>
                <a:solidFill>
                  <a:srgbClr val="FF0000"/>
                </a:solidFill>
                <a:latin typeface="Arial"/>
                <a:cs typeface="Arial"/>
              </a:rPr>
              <a:t>Ki-67</a:t>
            </a:r>
          </a:p>
        </p:txBody>
      </p:sp>
      <p:sp>
        <p:nvSpPr>
          <p:cNvPr id="178" name="Text Box 78"/>
          <p:cNvSpPr txBox="1">
            <a:spLocks noChangeArrowheads="1"/>
          </p:cNvSpPr>
          <p:nvPr/>
        </p:nvSpPr>
        <p:spPr bwMode="auto">
          <a:xfrm>
            <a:off x="3056697" y="628469"/>
            <a:ext cx="67669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Merged</a:t>
            </a:r>
          </a:p>
        </p:txBody>
      </p:sp>
      <p:cxnSp>
        <p:nvCxnSpPr>
          <p:cNvPr id="179" name="直線コネクタ 178"/>
          <p:cNvCxnSpPr/>
          <p:nvPr/>
        </p:nvCxnSpPr>
        <p:spPr>
          <a:xfrm>
            <a:off x="1277753" y="3428572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0" name="直線コネクタ 179"/>
          <p:cNvCxnSpPr/>
          <p:nvPr/>
        </p:nvCxnSpPr>
        <p:spPr>
          <a:xfrm rot="5400000" flipH="1" flipV="1">
            <a:off x="498704" y="2465076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1" name="直線コネクタ 180"/>
          <p:cNvCxnSpPr/>
          <p:nvPr/>
        </p:nvCxnSpPr>
        <p:spPr>
          <a:xfrm rot="5400000" flipH="1" flipV="1">
            <a:off x="1313935" y="2465076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2" name="直線コネクタ 181"/>
          <p:cNvCxnSpPr/>
          <p:nvPr/>
        </p:nvCxnSpPr>
        <p:spPr>
          <a:xfrm>
            <a:off x="1277753" y="2621242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3" name="直線コネクタ 182"/>
          <p:cNvCxnSpPr/>
          <p:nvPr/>
        </p:nvCxnSpPr>
        <p:spPr>
          <a:xfrm>
            <a:off x="1277753" y="1681063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4" name="Text Box 80"/>
          <p:cNvSpPr txBox="1">
            <a:spLocks noChangeArrowheads="1"/>
          </p:cNvSpPr>
          <p:nvPr/>
        </p:nvSpPr>
        <p:spPr bwMode="auto">
          <a:xfrm>
            <a:off x="4272586" y="628469"/>
            <a:ext cx="49323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 smtClean="0">
                <a:solidFill>
                  <a:srgbClr val="008000"/>
                </a:solidFill>
                <a:latin typeface="Arial"/>
                <a:cs typeface="Arial"/>
              </a:rPr>
              <a:t>EGFP</a:t>
            </a:r>
            <a:endParaRPr lang="en-US" altLang="ja-JP" sz="9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85" name="Text Box 82"/>
          <p:cNvSpPr txBox="1">
            <a:spLocks noChangeArrowheads="1"/>
          </p:cNvSpPr>
          <p:nvPr/>
        </p:nvSpPr>
        <p:spPr bwMode="auto">
          <a:xfrm>
            <a:off x="5797003" y="628469"/>
            <a:ext cx="67669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Merged</a:t>
            </a:r>
          </a:p>
        </p:txBody>
      </p:sp>
      <p:cxnSp>
        <p:nvCxnSpPr>
          <p:cNvPr id="186" name="直線コネクタ 185"/>
          <p:cNvCxnSpPr/>
          <p:nvPr/>
        </p:nvCxnSpPr>
        <p:spPr>
          <a:xfrm>
            <a:off x="4028574" y="3424842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7" name="直線コネクタ 186"/>
          <p:cNvCxnSpPr/>
          <p:nvPr/>
        </p:nvCxnSpPr>
        <p:spPr>
          <a:xfrm rot="5400000" flipH="1" flipV="1">
            <a:off x="3249525" y="2461346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4" name="直線コネクタ 193"/>
          <p:cNvCxnSpPr/>
          <p:nvPr/>
        </p:nvCxnSpPr>
        <p:spPr>
          <a:xfrm rot="5400000" flipH="1" flipV="1">
            <a:off x="4064756" y="2461346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5" name="直線コネクタ 194"/>
          <p:cNvCxnSpPr/>
          <p:nvPr/>
        </p:nvCxnSpPr>
        <p:spPr>
          <a:xfrm>
            <a:off x="4028574" y="2617512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6" name="直線コネクタ 195"/>
          <p:cNvCxnSpPr/>
          <p:nvPr/>
        </p:nvCxnSpPr>
        <p:spPr>
          <a:xfrm>
            <a:off x="4028574" y="1677333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7" name="Text Box 92"/>
          <p:cNvSpPr txBox="1">
            <a:spLocks noChangeArrowheads="1"/>
          </p:cNvSpPr>
          <p:nvPr/>
        </p:nvSpPr>
        <p:spPr bwMode="auto">
          <a:xfrm>
            <a:off x="4272587" y="4467263"/>
            <a:ext cx="49323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 smtClean="0">
                <a:solidFill>
                  <a:srgbClr val="008000"/>
                </a:solidFill>
                <a:latin typeface="Arial"/>
                <a:cs typeface="Arial"/>
              </a:rPr>
              <a:t>EGFP</a:t>
            </a:r>
            <a:endParaRPr lang="en-US" altLang="ja-JP" sz="9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98" name="Text Box 93"/>
          <p:cNvSpPr txBox="1">
            <a:spLocks noChangeArrowheads="1"/>
          </p:cNvSpPr>
          <p:nvPr/>
        </p:nvSpPr>
        <p:spPr bwMode="auto">
          <a:xfrm>
            <a:off x="5047687" y="4467263"/>
            <a:ext cx="56361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>
                <a:solidFill>
                  <a:srgbClr val="FF0000"/>
                </a:solidFill>
                <a:latin typeface="Arial"/>
                <a:cs typeface="Arial"/>
              </a:rPr>
              <a:t>NeuN</a:t>
            </a:r>
          </a:p>
        </p:txBody>
      </p:sp>
      <p:sp>
        <p:nvSpPr>
          <p:cNvPr id="199" name="Text Box 94"/>
          <p:cNvSpPr txBox="1">
            <a:spLocks noChangeArrowheads="1"/>
          </p:cNvSpPr>
          <p:nvPr/>
        </p:nvSpPr>
        <p:spPr bwMode="auto">
          <a:xfrm>
            <a:off x="5797003" y="4467263"/>
            <a:ext cx="67669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>
                <a:latin typeface="Arial"/>
                <a:cs typeface="Arial"/>
              </a:rPr>
              <a:t>Merged</a:t>
            </a:r>
          </a:p>
        </p:txBody>
      </p:sp>
      <p:cxnSp>
        <p:nvCxnSpPr>
          <p:cNvPr id="200" name="直線コネクタ 199"/>
          <p:cNvCxnSpPr/>
          <p:nvPr/>
        </p:nvCxnSpPr>
        <p:spPr>
          <a:xfrm>
            <a:off x="4024844" y="5526075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1" name="Text Box 88"/>
          <p:cNvSpPr txBox="1">
            <a:spLocks noChangeArrowheads="1"/>
          </p:cNvSpPr>
          <p:nvPr/>
        </p:nvSpPr>
        <p:spPr bwMode="auto">
          <a:xfrm>
            <a:off x="1524796" y="4467263"/>
            <a:ext cx="49323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 smtClean="0">
                <a:solidFill>
                  <a:srgbClr val="008000"/>
                </a:solidFill>
                <a:latin typeface="Arial"/>
                <a:cs typeface="Arial"/>
              </a:rPr>
              <a:t>EGFP</a:t>
            </a:r>
            <a:endParaRPr lang="en-US" altLang="ja-JP" sz="9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202" name="Text Box 90"/>
          <p:cNvSpPr txBox="1">
            <a:spLocks noChangeArrowheads="1"/>
          </p:cNvSpPr>
          <p:nvPr/>
        </p:nvSpPr>
        <p:spPr bwMode="auto">
          <a:xfrm>
            <a:off x="3056697" y="4467263"/>
            <a:ext cx="67669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Merged</a:t>
            </a:r>
          </a:p>
        </p:txBody>
      </p:sp>
      <p:cxnSp>
        <p:nvCxnSpPr>
          <p:cNvPr id="203" name="直線コネクタ 202"/>
          <p:cNvCxnSpPr/>
          <p:nvPr/>
        </p:nvCxnSpPr>
        <p:spPr>
          <a:xfrm>
            <a:off x="1277753" y="5526075"/>
            <a:ext cx="2563455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" name="図形グループ 125"/>
          <p:cNvGrpSpPr/>
          <p:nvPr/>
        </p:nvGrpSpPr>
        <p:grpSpPr>
          <a:xfrm>
            <a:off x="1375467" y="3437897"/>
            <a:ext cx="5155588" cy="790653"/>
            <a:chOff x="1375467" y="3320962"/>
            <a:chExt cx="5155588" cy="790653"/>
          </a:xfrm>
        </p:grpSpPr>
        <p:pic>
          <p:nvPicPr>
            <p:cNvPr id="205" name="Picture 29"/>
            <p:cNvPicPr>
              <a:picLocks noChangeAspect="1" noChangeArrowheads="1"/>
            </p:cNvPicPr>
            <p:nvPr/>
          </p:nvPicPr>
          <p:blipFill>
            <a:blip r:embed="rId2"/>
            <a:srcRect l="49872" b="50000"/>
            <a:stretch>
              <a:fillRect/>
            </a:stretch>
          </p:blipFill>
          <p:spPr bwMode="auto">
            <a:xfrm>
              <a:off x="1375467" y="3322827"/>
              <a:ext cx="791889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6" name="Picture 31"/>
            <p:cNvPicPr>
              <a:picLocks noChangeAspect="1" noChangeArrowheads="1"/>
            </p:cNvPicPr>
            <p:nvPr/>
          </p:nvPicPr>
          <p:blipFill>
            <a:blip r:embed="rId2"/>
            <a:srcRect t="50000" r="49872"/>
            <a:stretch>
              <a:fillRect/>
            </a:stretch>
          </p:blipFill>
          <p:spPr bwMode="auto">
            <a:xfrm>
              <a:off x="2186014" y="3322827"/>
              <a:ext cx="791855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7" name="Picture 31"/>
            <p:cNvPicPr>
              <a:picLocks noChangeAspect="1" noChangeArrowheads="1"/>
            </p:cNvPicPr>
            <p:nvPr/>
          </p:nvPicPr>
          <p:blipFill>
            <a:blip r:embed="rId2"/>
            <a:srcRect l="49872" t="50000"/>
            <a:stretch>
              <a:fillRect/>
            </a:stretch>
          </p:blipFill>
          <p:spPr bwMode="auto">
            <a:xfrm>
              <a:off x="2999111" y="3322827"/>
              <a:ext cx="791862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4" name="Picture 71"/>
            <p:cNvPicPr>
              <a:picLocks noChangeAspect="1" noChangeArrowheads="1"/>
            </p:cNvPicPr>
            <p:nvPr/>
          </p:nvPicPr>
          <p:blipFill>
            <a:blip r:embed="rId3"/>
            <a:srcRect l="49872" b="50000"/>
            <a:stretch>
              <a:fillRect/>
            </a:stretch>
          </p:blipFill>
          <p:spPr bwMode="auto">
            <a:xfrm>
              <a:off x="4123492" y="3320962"/>
              <a:ext cx="791420" cy="788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5" name="Picture 72"/>
            <p:cNvPicPr>
              <a:picLocks noChangeAspect="1" noChangeArrowheads="1"/>
            </p:cNvPicPr>
            <p:nvPr/>
          </p:nvPicPr>
          <p:blipFill>
            <a:blip r:embed="rId3"/>
            <a:srcRect t="50000" r="49872"/>
            <a:stretch>
              <a:fillRect/>
            </a:stretch>
          </p:blipFill>
          <p:spPr bwMode="auto">
            <a:xfrm>
              <a:off x="4933792" y="3320962"/>
              <a:ext cx="791399" cy="788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6" name="Picture 72"/>
            <p:cNvPicPr>
              <a:picLocks noChangeAspect="1" noChangeArrowheads="1"/>
            </p:cNvPicPr>
            <p:nvPr/>
          </p:nvPicPr>
          <p:blipFill>
            <a:blip r:embed="rId3"/>
            <a:srcRect l="49872" t="50000"/>
            <a:stretch>
              <a:fillRect/>
            </a:stretch>
          </p:blipFill>
          <p:spPr bwMode="auto">
            <a:xfrm>
              <a:off x="5739643" y="3320962"/>
              <a:ext cx="791412" cy="788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3" name="図形グループ 110"/>
          <p:cNvGrpSpPr/>
          <p:nvPr/>
        </p:nvGrpSpPr>
        <p:grpSpPr>
          <a:xfrm>
            <a:off x="1375467" y="2629458"/>
            <a:ext cx="5155588" cy="790651"/>
            <a:chOff x="1375467" y="1706196"/>
            <a:chExt cx="5155588" cy="790651"/>
          </a:xfrm>
        </p:grpSpPr>
        <p:pic>
          <p:nvPicPr>
            <p:cNvPr id="240" name="Picture 28"/>
            <p:cNvPicPr>
              <a:picLocks noChangeAspect="1" noChangeArrowheads="1"/>
            </p:cNvPicPr>
            <p:nvPr/>
          </p:nvPicPr>
          <p:blipFill>
            <a:blip r:embed="rId4"/>
            <a:srcRect l="49872" b="50000"/>
            <a:stretch>
              <a:fillRect/>
            </a:stretch>
          </p:blipFill>
          <p:spPr bwMode="auto">
            <a:xfrm>
              <a:off x="1375467" y="1708059"/>
              <a:ext cx="791889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1" name="Picture 30"/>
            <p:cNvPicPr>
              <a:picLocks noChangeAspect="1" noChangeArrowheads="1"/>
            </p:cNvPicPr>
            <p:nvPr/>
          </p:nvPicPr>
          <p:blipFill>
            <a:blip r:embed="rId4"/>
            <a:srcRect t="50000" r="49872"/>
            <a:stretch>
              <a:fillRect/>
            </a:stretch>
          </p:blipFill>
          <p:spPr bwMode="auto">
            <a:xfrm>
              <a:off x="2186007" y="1708059"/>
              <a:ext cx="791869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2" name="Picture 30"/>
            <p:cNvPicPr>
              <a:picLocks noChangeAspect="1" noChangeArrowheads="1"/>
            </p:cNvPicPr>
            <p:nvPr/>
          </p:nvPicPr>
          <p:blipFill>
            <a:blip r:embed="rId4"/>
            <a:srcRect l="49872" t="50000"/>
            <a:stretch>
              <a:fillRect/>
            </a:stretch>
          </p:blipFill>
          <p:spPr bwMode="auto">
            <a:xfrm>
              <a:off x="2999108" y="1708059"/>
              <a:ext cx="791869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3" name="Picture 64"/>
            <p:cNvPicPr>
              <a:picLocks noChangeAspect="1" noChangeArrowheads="1"/>
            </p:cNvPicPr>
            <p:nvPr/>
          </p:nvPicPr>
          <p:blipFill>
            <a:blip r:embed="rId5"/>
            <a:srcRect l="49872" b="50000"/>
            <a:stretch>
              <a:fillRect/>
            </a:stretch>
          </p:blipFill>
          <p:spPr bwMode="auto">
            <a:xfrm>
              <a:off x="4123492" y="1706196"/>
              <a:ext cx="791420" cy="788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4" name="Picture 65"/>
            <p:cNvPicPr>
              <a:picLocks noChangeAspect="1" noChangeArrowheads="1"/>
            </p:cNvPicPr>
            <p:nvPr/>
          </p:nvPicPr>
          <p:blipFill>
            <a:blip r:embed="rId5"/>
            <a:srcRect t="50000" r="49872"/>
            <a:stretch>
              <a:fillRect/>
            </a:stretch>
          </p:blipFill>
          <p:spPr bwMode="auto">
            <a:xfrm>
              <a:off x="4933792" y="1706196"/>
              <a:ext cx="791399" cy="788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5" name="Picture 65"/>
            <p:cNvPicPr>
              <a:picLocks noChangeAspect="1" noChangeArrowheads="1"/>
            </p:cNvPicPr>
            <p:nvPr/>
          </p:nvPicPr>
          <p:blipFill>
            <a:blip r:embed="rId5"/>
            <a:srcRect l="49872" t="50000"/>
            <a:stretch>
              <a:fillRect/>
            </a:stretch>
          </p:blipFill>
          <p:spPr bwMode="auto">
            <a:xfrm>
              <a:off x="5739643" y="1706196"/>
              <a:ext cx="791412" cy="788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47" name="テキスト ボックス 246"/>
          <p:cNvSpPr txBox="1"/>
          <p:nvPr/>
        </p:nvSpPr>
        <p:spPr>
          <a:xfrm>
            <a:off x="1024836" y="432788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248" name="テキスト ボックス 247"/>
          <p:cNvSpPr txBox="1"/>
          <p:nvPr/>
        </p:nvSpPr>
        <p:spPr>
          <a:xfrm>
            <a:off x="247020" y="110083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M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49" name="テキスト ボックス 248"/>
          <p:cNvSpPr txBox="1"/>
          <p:nvPr/>
        </p:nvSpPr>
        <p:spPr>
          <a:xfrm>
            <a:off x="225952" y="1313099"/>
            <a:ext cx="2616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H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50" name="フリーフォーム 249"/>
          <p:cNvSpPr/>
          <p:nvPr/>
        </p:nvSpPr>
        <p:spPr>
          <a:xfrm>
            <a:off x="250902" y="1307487"/>
            <a:ext cx="772439" cy="247140"/>
          </a:xfrm>
          <a:custGeom>
            <a:avLst/>
            <a:gdLst>
              <a:gd name="connsiteX0" fmla="*/ 102695 w 2816763"/>
              <a:gd name="connsiteY0" fmla="*/ 2096 h 901213"/>
              <a:gd name="connsiteX1" fmla="*/ 505089 w 2816763"/>
              <a:gd name="connsiteY1" fmla="*/ 52396 h 901213"/>
              <a:gd name="connsiteX2" fmla="*/ 1146406 w 2816763"/>
              <a:gd name="connsiteY2" fmla="*/ 228447 h 901213"/>
              <a:gd name="connsiteX3" fmla="*/ 1712273 w 2816763"/>
              <a:gd name="connsiteY3" fmla="*/ 316473 h 901213"/>
              <a:gd name="connsiteX4" fmla="*/ 2014069 w 2816763"/>
              <a:gd name="connsiteY4" fmla="*/ 329048 h 901213"/>
              <a:gd name="connsiteX5" fmla="*/ 2378740 w 2816763"/>
              <a:gd name="connsiteY5" fmla="*/ 241022 h 901213"/>
              <a:gd name="connsiteX6" fmla="*/ 2617661 w 2816763"/>
              <a:gd name="connsiteY6" fmla="*/ 152997 h 901213"/>
              <a:gd name="connsiteX7" fmla="*/ 2755985 w 2816763"/>
              <a:gd name="connsiteY7" fmla="*/ 203297 h 901213"/>
              <a:gd name="connsiteX8" fmla="*/ 2755985 w 2816763"/>
              <a:gd name="connsiteY8" fmla="*/ 366773 h 901213"/>
              <a:gd name="connsiteX9" fmla="*/ 2391314 w 2816763"/>
              <a:gd name="connsiteY9" fmla="*/ 655999 h 901213"/>
              <a:gd name="connsiteX10" fmla="*/ 1787722 w 2816763"/>
              <a:gd name="connsiteY10" fmla="*/ 806900 h 901213"/>
              <a:gd name="connsiteX11" fmla="*/ 1158981 w 2816763"/>
              <a:gd name="connsiteY11" fmla="*/ 731449 h 901213"/>
              <a:gd name="connsiteX12" fmla="*/ 643413 w 2816763"/>
              <a:gd name="connsiteY12" fmla="*/ 731449 h 901213"/>
              <a:gd name="connsiteX13" fmla="*/ 190719 w 2816763"/>
              <a:gd name="connsiteY13" fmla="*/ 819475 h 901213"/>
              <a:gd name="connsiteX14" fmla="*/ 39821 w 2816763"/>
              <a:gd name="connsiteY14" fmla="*/ 882350 h 901213"/>
              <a:gd name="connsiteX15" fmla="*/ 52395 w 2816763"/>
              <a:gd name="connsiteY15" fmla="*/ 706299 h 901213"/>
              <a:gd name="connsiteX16" fmla="*/ 354191 w 2816763"/>
              <a:gd name="connsiteY16" fmla="*/ 605699 h 901213"/>
              <a:gd name="connsiteX17" fmla="*/ 832035 w 2816763"/>
              <a:gd name="connsiteY17" fmla="*/ 580549 h 901213"/>
              <a:gd name="connsiteX18" fmla="*/ 1284729 w 2816763"/>
              <a:gd name="connsiteY18" fmla="*/ 630849 h 901213"/>
              <a:gd name="connsiteX19" fmla="*/ 1749998 w 2816763"/>
              <a:gd name="connsiteY19" fmla="*/ 630849 h 901213"/>
              <a:gd name="connsiteX20" fmla="*/ 1963770 w 2816763"/>
              <a:gd name="connsiteY20" fmla="*/ 593124 h 901213"/>
              <a:gd name="connsiteX21" fmla="*/ 2315865 w 2816763"/>
              <a:gd name="connsiteY21" fmla="*/ 467373 h 901213"/>
              <a:gd name="connsiteX22" fmla="*/ 2429039 w 2816763"/>
              <a:gd name="connsiteY22" fmla="*/ 417073 h 901213"/>
              <a:gd name="connsiteX23" fmla="*/ 2164967 w 2816763"/>
              <a:gd name="connsiteY23" fmla="*/ 479948 h 901213"/>
              <a:gd name="connsiteX24" fmla="*/ 1825447 w 2816763"/>
              <a:gd name="connsiteY24" fmla="*/ 530249 h 901213"/>
              <a:gd name="connsiteX25" fmla="*/ 1309879 w 2816763"/>
              <a:gd name="connsiteY25" fmla="*/ 442223 h 901213"/>
              <a:gd name="connsiteX26" fmla="*/ 718862 w 2816763"/>
              <a:gd name="connsiteY26" fmla="*/ 316473 h 901213"/>
              <a:gd name="connsiteX27" fmla="*/ 404491 w 2816763"/>
              <a:gd name="connsiteY27" fmla="*/ 215872 h 901213"/>
              <a:gd name="connsiteX28" fmla="*/ 102695 w 2816763"/>
              <a:gd name="connsiteY28" fmla="*/ 215872 h 901213"/>
              <a:gd name="connsiteX29" fmla="*/ 14671 w 2816763"/>
              <a:gd name="connsiteY29" fmla="*/ 215872 h 901213"/>
              <a:gd name="connsiteX30" fmla="*/ 27246 w 2816763"/>
              <a:gd name="connsiteY30" fmla="*/ 39821 h 901213"/>
              <a:gd name="connsiteX31" fmla="*/ 102695 w 2816763"/>
              <a:gd name="connsiteY31" fmla="*/ 2096 h 9012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2816763" h="901213">
                <a:moveTo>
                  <a:pt x="102695" y="2096"/>
                </a:moveTo>
                <a:cubicBezTo>
                  <a:pt x="182335" y="4192"/>
                  <a:pt x="331137" y="14671"/>
                  <a:pt x="505089" y="52396"/>
                </a:cubicBezTo>
                <a:cubicBezTo>
                  <a:pt x="679041" y="90121"/>
                  <a:pt x="945209" y="184434"/>
                  <a:pt x="1146406" y="228447"/>
                </a:cubicBezTo>
                <a:cubicBezTo>
                  <a:pt x="1347603" y="272460"/>
                  <a:pt x="1567663" y="299706"/>
                  <a:pt x="1712273" y="316473"/>
                </a:cubicBezTo>
                <a:cubicBezTo>
                  <a:pt x="1856883" y="333240"/>
                  <a:pt x="1902991" y="341623"/>
                  <a:pt x="2014069" y="329048"/>
                </a:cubicBezTo>
                <a:cubicBezTo>
                  <a:pt x="2125147" y="316473"/>
                  <a:pt x="2278141" y="270364"/>
                  <a:pt x="2378740" y="241022"/>
                </a:cubicBezTo>
                <a:cubicBezTo>
                  <a:pt x="2479339" y="211680"/>
                  <a:pt x="2554787" y="159284"/>
                  <a:pt x="2617661" y="152997"/>
                </a:cubicBezTo>
                <a:cubicBezTo>
                  <a:pt x="2680535" y="146710"/>
                  <a:pt x="2732931" y="167668"/>
                  <a:pt x="2755985" y="203297"/>
                </a:cubicBezTo>
                <a:cubicBezTo>
                  <a:pt x="2779039" y="238926"/>
                  <a:pt x="2816763" y="291323"/>
                  <a:pt x="2755985" y="366773"/>
                </a:cubicBezTo>
                <a:cubicBezTo>
                  <a:pt x="2695207" y="442223"/>
                  <a:pt x="2552691" y="582645"/>
                  <a:pt x="2391314" y="655999"/>
                </a:cubicBezTo>
                <a:cubicBezTo>
                  <a:pt x="2229937" y="729354"/>
                  <a:pt x="1993111" y="794325"/>
                  <a:pt x="1787722" y="806900"/>
                </a:cubicBezTo>
                <a:cubicBezTo>
                  <a:pt x="1582333" y="819475"/>
                  <a:pt x="1349699" y="744024"/>
                  <a:pt x="1158981" y="731449"/>
                </a:cubicBezTo>
                <a:cubicBezTo>
                  <a:pt x="968263" y="718874"/>
                  <a:pt x="804790" y="716778"/>
                  <a:pt x="643413" y="731449"/>
                </a:cubicBezTo>
                <a:cubicBezTo>
                  <a:pt x="482036" y="746120"/>
                  <a:pt x="291318" y="794325"/>
                  <a:pt x="190719" y="819475"/>
                </a:cubicBezTo>
                <a:cubicBezTo>
                  <a:pt x="90120" y="844625"/>
                  <a:pt x="62875" y="901213"/>
                  <a:pt x="39821" y="882350"/>
                </a:cubicBezTo>
                <a:cubicBezTo>
                  <a:pt x="16767" y="863487"/>
                  <a:pt x="0" y="752407"/>
                  <a:pt x="52395" y="706299"/>
                </a:cubicBezTo>
                <a:cubicBezTo>
                  <a:pt x="104790" y="660191"/>
                  <a:pt x="224251" y="626657"/>
                  <a:pt x="354191" y="605699"/>
                </a:cubicBezTo>
                <a:cubicBezTo>
                  <a:pt x="484131" y="584741"/>
                  <a:pt x="676945" y="576357"/>
                  <a:pt x="832035" y="580549"/>
                </a:cubicBezTo>
                <a:cubicBezTo>
                  <a:pt x="987125" y="584741"/>
                  <a:pt x="1131735" y="622466"/>
                  <a:pt x="1284729" y="630849"/>
                </a:cubicBezTo>
                <a:cubicBezTo>
                  <a:pt x="1437723" y="639232"/>
                  <a:pt x="1636824" y="637137"/>
                  <a:pt x="1749998" y="630849"/>
                </a:cubicBezTo>
                <a:cubicBezTo>
                  <a:pt x="1863172" y="624561"/>
                  <a:pt x="1869459" y="620370"/>
                  <a:pt x="1963770" y="593124"/>
                </a:cubicBezTo>
                <a:cubicBezTo>
                  <a:pt x="2058081" y="565878"/>
                  <a:pt x="2238320" y="496715"/>
                  <a:pt x="2315865" y="467373"/>
                </a:cubicBezTo>
                <a:cubicBezTo>
                  <a:pt x="2393410" y="438031"/>
                  <a:pt x="2454189" y="414977"/>
                  <a:pt x="2429039" y="417073"/>
                </a:cubicBezTo>
                <a:cubicBezTo>
                  <a:pt x="2403889" y="419169"/>
                  <a:pt x="2265566" y="461085"/>
                  <a:pt x="2164967" y="479948"/>
                </a:cubicBezTo>
                <a:cubicBezTo>
                  <a:pt x="2064368" y="498811"/>
                  <a:pt x="1967962" y="536536"/>
                  <a:pt x="1825447" y="530249"/>
                </a:cubicBezTo>
                <a:cubicBezTo>
                  <a:pt x="1682932" y="523962"/>
                  <a:pt x="1494310" y="477852"/>
                  <a:pt x="1309879" y="442223"/>
                </a:cubicBezTo>
                <a:cubicBezTo>
                  <a:pt x="1125448" y="406594"/>
                  <a:pt x="869760" y="354198"/>
                  <a:pt x="718862" y="316473"/>
                </a:cubicBezTo>
                <a:cubicBezTo>
                  <a:pt x="567964" y="278748"/>
                  <a:pt x="507186" y="232639"/>
                  <a:pt x="404491" y="215872"/>
                </a:cubicBezTo>
                <a:cubicBezTo>
                  <a:pt x="301797" y="199105"/>
                  <a:pt x="102695" y="215872"/>
                  <a:pt x="102695" y="215872"/>
                </a:cubicBezTo>
                <a:cubicBezTo>
                  <a:pt x="37725" y="215872"/>
                  <a:pt x="27246" y="245214"/>
                  <a:pt x="14671" y="215872"/>
                </a:cubicBezTo>
                <a:cubicBezTo>
                  <a:pt x="2096" y="186530"/>
                  <a:pt x="10480" y="73354"/>
                  <a:pt x="27246" y="39821"/>
                </a:cubicBezTo>
                <a:cubicBezTo>
                  <a:pt x="44012" y="6288"/>
                  <a:pt x="23055" y="0"/>
                  <a:pt x="102695" y="2096"/>
                </a:cubicBezTo>
                <a:close/>
              </a:path>
            </a:pathLst>
          </a:custGeom>
          <a:solidFill>
            <a:schemeClr val="bg1">
              <a:lumMod val="75000"/>
            </a:schemeClr>
          </a:solidFill>
          <a:ln w="9525" cap="flat" cmpd="sng" algn="ctr">
            <a:solidFill>
              <a:srgbClr val="00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1" name="正方形/長方形 250"/>
          <p:cNvSpPr/>
          <p:nvPr/>
        </p:nvSpPr>
        <p:spPr>
          <a:xfrm>
            <a:off x="182509" y="994384"/>
            <a:ext cx="109014" cy="6431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2" name="フリーフォーム 251"/>
          <p:cNvSpPr/>
          <p:nvPr/>
        </p:nvSpPr>
        <p:spPr>
          <a:xfrm>
            <a:off x="293700" y="1113530"/>
            <a:ext cx="769680" cy="189228"/>
          </a:xfrm>
          <a:custGeom>
            <a:avLst/>
            <a:gdLst>
              <a:gd name="connsiteX0" fmla="*/ 0 w 2806700"/>
              <a:gd name="connsiteY0" fmla="*/ 0 h 690034"/>
              <a:gd name="connsiteX1" fmla="*/ 461434 w 2806700"/>
              <a:gd name="connsiteY1" fmla="*/ 59267 h 690034"/>
              <a:gd name="connsiteX2" fmla="*/ 1032934 w 2806700"/>
              <a:gd name="connsiteY2" fmla="*/ 152400 h 690034"/>
              <a:gd name="connsiteX3" fmla="*/ 1642534 w 2806700"/>
              <a:gd name="connsiteY3" fmla="*/ 304800 h 690034"/>
              <a:gd name="connsiteX4" fmla="*/ 2146300 w 2806700"/>
              <a:gd name="connsiteY4" fmla="*/ 419100 h 690034"/>
              <a:gd name="connsiteX5" fmla="*/ 2628900 w 2806700"/>
              <a:gd name="connsiteY5" fmla="*/ 554567 h 690034"/>
              <a:gd name="connsiteX6" fmla="*/ 2768600 w 2806700"/>
              <a:gd name="connsiteY6" fmla="*/ 622300 h 690034"/>
              <a:gd name="connsiteX7" fmla="*/ 2806700 w 2806700"/>
              <a:gd name="connsiteY7" fmla="*/ 690034 h 6900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2806700" h="690034">
                <a:moveTo>
                  <a:pt x="0" y="0"/>
                </a:moveTo>
                <a:cubicBezTo>
                  <a:pt x="144639" y="16933"/>
                  <a:pt x="289278" y="33867"/>
                  <a:pt x="461434" y="59267"/>
                </a:cubicBezTo>
                <a:cubicBezTo>
                  <a:pt x="633590" y="84667"/>
                  <a:pt x="836084" y="111478"/>
                  <a:pt x="1032934" y="152400"/>
                </a:cubicBezTo>
                <a:cubicBezTo>
                  <a:pt x="1229784" y="193322"/>
                  <a:pt x="1456973" y="260350"/>
                  <a:pt x="1642534" y="304800"/>
                </a:cubicBezTo>
                <a:cubicBezTo>
                  <a:pt x="1828095" y="349250"/>
                  <a:pt x="1981906" y="377472"/>
                  <a:pt x="2146300" y="419100"/>
                </a:cubicBezTo>
                <a:cubicBezTo>
                  <a:pt x="2310694" y="460728"/>
                  <a:pt x="2525183" y="520700"/>
                  <a:pt x="2628900" y="554567"/>
                </a:cubicBezTo>
                <a:cubicBezTo>
                  <a:pt x="2732617" y="588434"/>
                  <a:pt x="2738967" y="599722"/>
                  <a:pt x="2768600" y="622300"/>
                </a:cubicBezTo>
                <a:cubicBezTo>
                  <a:pt x="2798233" y="644878"/>
                  <a:pt x="2802466" y="667456"/>
                  <a:pt x="2806700" y="690034"/>
                </a:cubicBezTo>
              </a:path>
            </a:pathLst>
          </a:custGeom>
          <a:ln w="9525" cap="flat" cmpd="sng" algn="ctr">
            <a:solidFill>
              <a:srgbClr val="00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3" name="フリーフォーム 252"/>
          <p:cNvSpPr/>
          <p:nvPr/>
        </p:nvSpPr>
        <p:spPr>
          <a:xfrm>
            <a:off x="904335" y="1537261"/>
            <a:ext cx="160205" cy="119573"/>
          </a:xfrm>
          <a:custGeom>
            <a:avLst/>
            <a:gdLst>
              <a:gd name="connsiteX0" fmla="*/ 584200 w 584200"/>
              <a:gd name="connsiteY0" fmla="*/ 0 h 436033"/>
              <a:gd name="connsiteX1" fmla="*/ 431800 w 584200"/>
              <a:gd name="connsiteY1" fmla="*/ 190500 h 436033"/>
              <a:gd name="connsiteX2" fmla="*/ 148167 w 584200"/>
              <a:gd name="connsiteY2" fmla="*/ 376767 h 436033"/>
              <a:gd name="connsiteX3" fmla="*/ 0 w 584200"/>
              <a:gd name="connsiteY3" fmla="*/ 436033 h 4360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84200" h="436033">
                <a:moveTo>
                  <a:pt x="584200" y="0"/>
                </a:moveTo>
                <a:cubicBezTo>
                  <a:pt x="544336" y="63853"/>
                  <a:pt x="504472" y="127706"/>
                  <a:pt x="431800" y="190500"/>
                </a:cubicBezTo>
                <a:cubicBezTo>
                  <a:pt x="359128" y="253294"/>
                  <a:pt x="220134" y="335845"/>
                  <a:pt x="148167" y="376767"/>
                </a:cubicBezTo>
                <a:cubicBezTo>
                  <a:pt x="76200" y="417689"/>
                  <a:pt x="38100" y="426861"/>
                  <a:pt x="0" y="436033"/>
                </a:cubicBezTo>
              </a:path>
            </a:pathLst>
          </a:custGeom>
          <a:ln w="9525" cap="flat" cmpd="sng" algn="ctr">
            <a:solidFill>
              <a:srgbClr val="00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4" name="正方形/長方形 253"/>
          <p:cNvSpPr/>
          <p:nvPr/>
        </p:nvSpPr>
        <p:spPr>
          <a:xfrm>
            <a:off x="291523" y="886862"/>
            <a:ext cx="773496" cy="771483"/>
          </a:xfrm>
          <a:prstGeom prst="rect">
            <a:avLst/>
          </a:prstGeom>
          <a:noFill/>
          <a:ln w="12700" cap="flat" cmpd="sng" algn="ctr">
            <a:solidFill>
              <a:schemeClr val="tx2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5" name="テキスト ボックス 254"/>
          <p:cNvSpPr txBox="1"/>
          <p:nvPr/>
        </p:nvSpPr>
        <p:spPr>
          <a:xfrm>
            <a:off x="416297" y="125582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GC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56" name="フリーフォーム 255"/>
          <p:cNvSpPr/>
          <p:nvPr/>
        </p:nvSpPr>
        <p:spPr>
          <a:xfrm>
            <a:off x="254925" y="2971472"/>
            <a:ext cx="478751" cy="466692"/>
          </a:xfrm>
          <a:custGeom>
            <a:avLst/>
            <a:gdLst>
              <a:gd name="connsiteX0" fmla="*/ 125748 w 1745806"/>
              <a:gd name="connsiteY0" fmla="*/ 85929 h 1701824"/>
              <a:gd name="connsiteX1" fmla="*/ 804789 w 1745806"/>
              <a:gd name="connsiteY1" fmla="*/ 676956 h 1701824"/>
              <a:gd name="connsiteX2" fmla="*/ 1257483 w 1745806"/>
              <a:gd name="connsiteY2" fmla="*/ 1066783 h 1701824"/>
              <a:gd name="connsiteX3" fmla="*/ 1584429 w 1745806"/>
              <a:gd name="connsiteY3" fmla="*/ 1418885 h 1701824"/>
              <a:gd name="connsiteX4" fmla="*/ 1722752 w 1745806"/>
              <a:gd name="connsiteY4" fmla="*/ 1657811 h 1701824"/>
              <a:gd name="connsiteX5" fmla="*/ 1559279 w 1745806"/>
              <a:gd name="connsiteY5" fmla="*/ 1682961 h 1701824"/>
              <a:gd name="connsiteX6" fmla="*/ 603592 w 1745806"/>
              <a:gd name="connsiteY6" fmla="*/ 1657811 h 1701824"/>
              <a:gd name="connsiteX7" fmla="*/ 528143 w 1745806"/>
              <a:gd name="connsiteY7" fmla="*/ 1569785 h 1701824"/>
              <a:gd name="connsiteX8" fmla="*/ 264071 w 1745806"/>
              <a:gd name="connsiteY8" fmla="*/ 1205109 h 1701824"/>
              <a:gd name="connsiteX9" fmla="*/ 37724 w 1745806"/>
              <a:gd name="connsiteY9" fmla="*/ 1041633 h 1701824"/>
              <a:gd name="connsiteX10" fmla="*/ 37724 w 1745806"/>
              <a:gd name="connsiteY10" fmla="*/ 890732 h 1701824"/>
              <a:gd name="connsiteX11" fmla="*/ 37724 w 1745806"/>
              <a:gd name="connsiteY11" fmla="*/ 186529 h 1701824"/>
              <a:gd name="connsiteX12" fmla="*/ 125748 w 1745806"/>
              <a:gd name="connsiteY12" fmla="*/ 161379 h 1701824"/>
              <a:gd name="connsiteX13" fmla="*/ 125748 w 1745806"/>
              <a:gd name="connsiteY13" fmla="*/ 85929 h 17018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745806" h="1701824">
                <a:moveTo>
                  <a:pt x="125748" y="85929"/>
                </a:moveTo>
                <a:cubicBezTo>
                  <a:pt x="238921" y="171858"/>
                  <a:pt x="804789" y="676956"/>
                  <a:pt x="804789" y="676956"/>
                </a:cubicBezTo>
                <a:cubicBezTo>
                  <a:pt x="993411" y="840432"/>
                  <a:pt x="1127543" y="943128"/>
                  <a:pt x="1257483" y="1066783"/>
                </a:cubicBezTo>
                <a:cubicBezTo>
                  <a:pt x="1387423" y="1190438"/>
                  <a:pt x="1506884" y="1320380"/>
                  <a:pt x="1584429" y="1418885"/>
                </a:cubicBezTo>
                <a:cubicBezTo>
                  <a:pt x="1661974" y="1517390"/>
                  <a:pt x="1726944" y="1613798"/>
                  <a:pt x="1722752" y="1657811"/>
                </a:cubicBezTo>
                <a:cubicBezTo>
                  <a:pt x="1718560" y="1701824"/>
                  <a:pt x="1745806" y="1682961"/>
                  <a:pt x="1559279" y="1682961"/>
                </a:cubicBezTo>
                <a:cubicBezTo>
                  <a:pt x="1372752" y="1682961"/>
                  <a:pt x="775448" y="1676674"/>
                  <a:pt x="603592" y="1657811"/>
                </a:cubicBezTo>
                <a:cubicBezTo>
                  <a:pt x="431736" y="1638948"/>
                  <a:pt x="584730" y="1645235"/>
                  <a:pt x="528143" y="1569785"/>
                </a:cubicBezTo>
                <a:cubicBezTo>
                  <a:pt x="471556" y="1494335"/>
                  <a:pt x="345807" y="1293134"/>
                  <a:pt x="264071" y="1205109"/>
                </a:cubicBezTo>
                <a:cubicBezTo>
                  <a:pt x="182335" y="1117084"/>
                  <a:pt x="75448" y="1094029"/>
                  <a:pt x="37724" y="1041633"/>
                </a:cubicBezTo>
                <a:cubicBezTo>
                  <a:pt x="0" y="989237"/>
                  <a:pt x="37724" y="890732"/>
                  <a:pt x="37724" y="890732"/>
                </a:cubicBezTo>
                <a:cubicBezTo>
                  <a:pt x="37724" y="748215"/>
                  <a:pt x="23053" y="308088"/>
                  <a:pt x="37724" y="186529"/>
                </a:cubicBezTo>
                <a:cubicBezTo>
                  <a:pt x="52395" y="64970"/>
                  <a:pt x="106886" y="173954"/>
                  <a:pt x="125748" y="161379"/>
                </a:cubicBezTo>
                <a:cubicBezTo>
                  <a:pt x="144610" y="148804"/>
                  <a:pt x="12575" y="0"/>
                  <a:pt x="125748" y="85929"/>
                </a:cubicBezTo>
                <a:close/>
              </a:path>
            </a:pathLst>
          </a:custGeom>
          <a:solidFill>
            <a:schemeClr val="bg1">
              <a:lumMod val="75000"/>
            </a:schemeClr>
          </a:solidFill>
          <a:ln w="12700" cap="flat" cmpd="sng" algn="ctr">
            <a:solidFill>
              <a:schemeClr val="tx1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7" name="正方形/長方形 256"/>
          <p:cNvSpPr/>
          <p:nvPr/>
        </p:nvSpPr>
        <p:spPr>
          <a:xfrm>
            <a:off x="182509" y="2795026"/>
            <a:ext cx="109014" cy="6431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8" name="正方形/長方形 257"/>
          <p:cNvSpPr/>
          <p:nvPr/>
        </p:nvSpPr>
        <p:spPr>
          <a:xfrm rot="5400000">
            <a:off x="558584" y="3137370"/>
            <a:ext cx="109015" cy="6431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9" name="正方形/長方形 258"/>
          <p:cNvSpPr/>
          <p:nvPr/>
        </p:nvSpPr>
        <p:spPr>
          <a:xfrm>
            <a:off x="291523" y="2632948"/>
            <a:ext cx="773496" cy="771483"/>
          </a:xfrm>
          <a:prstGeom prst="rect">
            <a:avLst/>
          </a:prstGeom>
          <a:noFill/>
          <a:ln w="12700" cap="flat" cmpd="sng" algn="ctr">
            <a:solidFill>
              <a:srgbClr val="00009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60" name="テキスト ボックス 259"/>
          <p:cNvSpPr txBox="1"/>
          <p:nvPr/>
        </p:nvSpPr>
        <p:spPr>
          <a:xfrm>
            <a:off x="291523" y="31554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GC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61" name="テキスト ボックス 260"/>
          <p:cNvSpPr txBox="1"/>
          <p:nvPr/>
        </p:nvSpPr>
        <p:spPr>
          <a:xfrm>
            <a:off x="293700" y="275084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M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62" name="テキスト ボックス 261"/>
          <p:cNvSpPr txBox="1"/>
          <p:nvPr/>
        </p:nvSpPr>
        <p:spPr>
          <a:xfrm>
            <a:off x="4910675" y="628469"/>
            <a:ext cx="8326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solidFill>
                  <a:srgbClr val="FF0000"/>
                </a:solidFill>
                <a:latin typeface="Arial"/>
                <a:cs typeface="Arial"/>
              </a:rPr>
              <a:t>Doublecortin</a:t>
            </a:r>
            <a:endParaRPr kumimoji="1" lang="ja-JP" altLang="en-US" sz="9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63" name="テキスト ボックス 262"/>
          <p:cNvSpPr txBox="1"/>
          <p:nvPr/>
        </p:nvSpPr>
        <p:spPr>
          <a:xfrm>
            <a:off x="2244001" y="4467263"/>
            <a:ext cx="672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solidFill>
                  <a:srgbClr val="FF0000"/>
                </a:solidFill>
                <a:latin typeface="Arial"/>
                <a:cs typeface="Arial"/>
              </a:rPr>
              <a:t>Calretinin</a:t>
            </a:r>
            <a:endParaRPr kumimoji="1" lang="ja-JP" altLang="en-US" sz="9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pic>
        <p:nvPicPr>
          <p:cNvPr id="265" name="Picture 10"/>
          <p:cNvPicPr>
            <a:picLocks noChangeAspect="1" noChangeArrowheads="1"/>
          </p:cNvPicPr>
          <p:nvPr/>
        </p:nvPicPr>
        <p:blipFill>
          <a:blip r:embed="rId6"/>
          <a:srcRect l="49877" b="50000"/>
          <a:stretch>
            <a:fillRect/>
          </a:stretch>
        </p:blipFill>
        <p:spPr bwMode="auto">
          <a:xfrm>
            <a:off x="1375512" y="881139"/>
            <a:ext cx="791799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6" name="Picture 22"/>
          <p:cNvPicPr>
            <a:picLocks noChangeAspect="1" noChangeArrowheads="1"/>
          </p:cNvPicPr>
          <p:nvPr/>
        </p:nvPicPr>
        <p:blipFill>
          <a:blip r:embed="rId6"/>
          <a:srcRect t="50000" r="49877"/>
          <a:stretch>
            <a:fillRect/>
          </a:stretch>
        </p:blipFill>
        <p:spPr bwMode="auto">
          <a:xfrm>
            <a:off x="2186050" y="881139"/>
            <a:ext cx="791786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7" name="Picture 22"/>
          <p:cNvPicPr>
            <a:picLocks noChangeAspect="1" noChangeArrowheads="1"/>
          </p:cNvPicPr>
          <p:nvPr/>
        </p:nvPicPr>
        <p:blipFill>
          <a:blip r:embed="rId6"/>
          <a:srcRect l="49877" t="50000"/>
          <a:stretch>
            <a:fillRect/>
          </a:stretch>
        </p:blipFill>
        <p:spPr bwMode="auto">
          <a:xfrm>
            <a:off x="2999151" y="881139"/>
            <a:ext cx="791783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8" name="Picture 62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 rot="5400000">
            <a:off x="4124807" y="878984"/>
            <a:ext cx="788789" cy="7893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9" name="Picture 61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 rot="5400000">
            <a:off x="4935098" y="878984"/>
            <a:ext cx="788789" cy="7893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0" name="Picture 60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 rot="5400000">
            <a:off x="5740954" y="878984"/>
            <a:ext cx="788789" cy="7893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1" name="Picture 40"/>
          <p:cNvPicPr>
            <a:picLocks noChangeAspect="1" noChangeArrowheads="1"/>
          </p:cNvPicPr>
          <p:nvPr/>
        </p:nvPicPr>
        <p:blipFill>
          <a:blip r:embed="rId10"/>
          <a:srcRect l="49872" b="50000"/>
          <a:stretch>
            <a:fillRect/>
          </a:stretch>
        </p:blipFill>
        <p:spPr bwMode="auto">
          <a:xfrm>
            <a:off x="1375512" y="7284773"/>
            <a:ext cx="791889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2" name="Picture 44"/>
          <p:cNvPicPr>
            <a:picLocks noChangeAspect="1" noChangeArrowheads="1"/>
          </p:cNvPicPr>
          <p:nvPr/>
        </p:nvPicPr>
        <p:blipFill>
          <a:blip r:embed="rId10"/>
          <a:srcRect t="50000" r="49872"/>
          <a:stretch>
            <a:fillRect/>
          </a:stretch>
        </p:blipFill>
        <p:spPr bwMode="auto">
          <a:xfrm>
            <a:off x="2186051" y="7284773"/>
            <a:ext cx="791873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3" name="Picture 47"/>
          <p:cNvPicPr>
            <a:picLocks noChangeAspect="1" noChangeArrowheads="1"/>
          </p:cNvPicPr>
          <p:nvPr/>
        </p:nvPicPr>
        <p:blipFill>
          <a:blip r:embed="rId11"/>
          <a:srcRect l="49872" b="50000"/>
          <a:stretch>
            <a:fillRect/>
          </a:stretch>
        </p:blipFill>
        <p:spPr bwMode="auto">
          <a:xfrm>
            <a:off x="4123302" y="7284773"/>
            <a:ext cx="791889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4" name="Picture 53"/>
          <p:cNvPicPr>
            <a:picLocks noChangeAspect="1" noChangeArrowheads="1"/>
          </p:cNvPicPr>
          <p:nvPr/>
        </p:nvPicPr>
        <p:blipFill>
          <a:blip r:embed="rId11"/>
          <a:srcRect t="50000" r="49872"/>
          <a:stretch>
            <a:fillRect/>
          </a:stretch>
        </p:blipFill>
        <p:spPr bwMode="auto">
          <a:xfrm>
            <a:off x="4933607" y="7284773"/>
            <a:ext cx="791860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5" name="Picture 53"/>
          <p:cNvPicPr>
            <a:picLocks noChangeAspect="1" noChangeArrowheads="1"/>
          </p:cNvPicPr>
          <p:nvPr/>
        </p:nvPicPr>
        <p:blipFill>
          <a:blip r:embed="rId11"/>
          <a:srcRect l="49872" t="50000"/>
          <a:stretch>
            <a:fillRect/>
          </a:stretch>
        </p:blipFill>
        <p:spPr bwMode="auto">
          <a:xfrm>
            <a:off x="5739463" y="7284773"/>
            <a:ext cx="791860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" name="Picture 44"/>
          <p:cNvPicPr>
            <a:picLocks noChangeAspect="1" noChangeArrowheads="1"/>
          </p:cNvPicPr>
          <p:nvPr/>
        </p:nvPicPr>
        <p:blipFill>
          <a:blip r:embed="rId10"/>
          <a:srcRect l="49872" t="50000"/>
          <a:stretch>
            <a:fillRect/>
          </a:stretch>
        </p:blipFill>
        <p:spPr bwMode="auto">
          <a:xfrm>
            <a:off x="2999155" y="7284773"/>
            <a:ext cx="791866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7" name="Picture 37"/>
          <p:cNvPicPr>
            <a:picLocks noChangeAspect="1" noChangeArrowheads="1"/>
          </p:cNvPicPr>
          <p:nvPr/>
        </p:nvPicPr>
        <p:blipFill>
          <a:blip r:embed="rId12"/>
          <a:srcRect l="49872" b="50000"/>
          <a:stretch>
            <a:fillRect/>
          </a:stretch>
        </p:blipFill>
        <p:spPr bwMode="auto">
          <a:xfrm>
            <a:off x="1375467" y="4723663"/>
            <a:ext cx="791889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8" name="Picture 41"/>
          <p:cNvPicPr>
            <a:picLocks noChangeAspect="1" noChangeArrowheads="1"/>
          </p:cNvPicPr>
          <p:nvPr/>
        </p:nvPicPr>
        <p:blipFill>
          <a:blip r:embed="rId12"/>
          <a:srcRect t="50000" r="49872"/>
          <a:stretch>
            <a:fillRect/>
          </a:stretch>
        </p:blipFill>
        <p:spPr bwMode="auto">
          <a:xfrm>
            <a:off x="2186006" y="4723663"/>
            <a:ext cx="791873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9" name="Picture 56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 flipH="1">
            <a:off x="4124285" y="4723663"/>
            <a:ext cx="789834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80" name="Picture 55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 flipH="1">
            <a:off x="4934575" y="4723663"/>
            <a:ext cx="789834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81" name="Picture 54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 flipH="1">
            <a:off x="5740431" y="4723663"/>
            <a:ext cx="789834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82" name="Picture 41"/>
          <p:cNvPicPr>
            <a:picLocks noChangeAspect="1" noChangeArrowheads="1"/>
          </p:cNvPicPr>
          <p:nvPr/>
        </p:nvPicPr>
        <p:blipFill>
          <a:blip r:embed="rId12"/>
          <a:srcRect l="49872" t="50000"/>
          <a:stretch>
            <a:fillRect/>
          </a:stretch>
        </p:blipFill>
        <p:spPr bwMode="auto">
          <a:xfrm>
            <a:off x="2999110" y="4723663"/>
            <a:ext cx="791866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5" name="図形グループ 123"/>
          <p:cNvGrpSpPr/>
          <p:nvPr/>
        </p:nvGrpSpPr>
        <p:grpSpPr>
          <a:xfrm>
            <a:off x="1375467" y="1686658"/>
            <a:ext cx="5154566" cy="790653"/>
            <a:chOff x="1375467" y="2513578"/>
            <a:chExt cx="5154566" cy="790653"/>
          </a:xfrm>
        </p:grpSpPr>
        <p:pic>
          <p:nvPicPr>
            <p:cNvPr id="284" name="Picture 23"/>
            <p:cNvPicPr>
              <a:picLocks noChangeAspect="1" noChangeArrowheads="1"/>
            </p:cNvPicPr>
            <p:nvPr/>
          </p:nvPicPr>
          <p:blipFill>
            <a:blip r:embed="rId16"/>
            <a:srcRect l="49872" b="50000"/>
            <a:stretch>
              <a:fillRect/>
            </a:stretch>
          </p:blipFill>
          <p:spPr bwMode="auto">
            <a:xfrm>
              <a:off x="1375467" y="2515443"/>
              <a:ext cx="791889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5" name="Picture 11"/>
            <p:cNvPicPr>
              <a:picLocks noChangeAspect="1" noChangeArrowheads="1"/>
            </p:cNvPicPr>
            <p:nvPr/>
          </p:nvPicPr>
          <p:blipFill>
            <a:blip r:embed="rId17"/>
            <a:srcRect t="50000" r="49877"/>
            <a:stretch>
              <a:fillRect/>
            </a:stretch>
          </p:blipFill>
          <p:spPr bwMode="auto">
            <a:xfrm>
              <a:off x="2186047" y="2515443"/>
              <a:ext cx="791789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6" name="Picture 11"/>
            <p:cNvPicPr>
              <a:picLocks noChangeAspect="1" noChangeArrowheads="1"/>
            </p:cNvPicPr>
            <p:nvPr/>
          </p:nvPicPr>
          <p:blipFill>
            <a:blip r:embed="rId17"/>
            <a:srcRect l="49877" t="50000"/>
            <a:stretch>
              <a:fillRect/>
            </a:stretch>
          </p:blipFill>
          <p:spPr bwMode="auto">
            <a:xfrm>
              <a:off x="2999149" y="2515443"/>
              <a:ext cx="791788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7" name="Picture 69"/>
            <p:cNvPicPr>
              <a:picLocks noChangeAspect="1" noChangeArrowheads="1"/>
            </p:cNvPicPr>
            <p:nvPr/>
          </p:nvPicPr>
          <p:blipFill>
            <a:blip r:embed="rId18"/>
            <a:srcRect/>
            <a:stretch>
              <a:fillRect/>
            </a:stretch>
          </p:blipFill>
          <p:spPr bwMode="auto">
            <a:xfrm rot="5400000">
              <a:off x="4124807" y="2513288"/>
              <a:ext cx="788789" cy="789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8" name="Picture 68"/>
            <p:cNvPicPr>
              <a:picLocks noChangeAspect="1" noChangeArrowheads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 bwMode="auto">
            <a:xfrm rot="5400000">
              <a:off x="4935098" y="2513288"/>
              <a:ext cx="788789" cy="789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9" name="Picture 67"/>
            <p:cNvPicPr>
              <a:picLocks noChangeAspect="1" noChangeArrowheads="1"/>
            </p:cNvPicPr>
            <p:nvPr/>
          </p:nvPicPr>
          <p:blipFill>
            <a:blip r:embed="rId20"/>
            <a:srcRect/>
            <a:stretch>
              <a:fillRect/>
            </a:stretch>
          </p:blipFill>
          <p:spPr bwMode="auto">
            <a:xfrm rot="5400000">
              <a:off x="5740954" y="2513288"/>
              <a:ext cx="788789" cy="789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290" name="Picture 39"/>
          <p:cNvPicPr>
            <a:picLocks noChangeAspect="1" noChangeArrowheads="1"/>
          </p:cNvPicPr>
          <p:nvPr/>
        </p:nvPicPr>
        <p:blipFill>
          <a:blip r:embed="rId21"/>
          <a:srcRect l="49872" b="50000"/>
          <a:stretch>
            <a:fillRect/>
          </a:stretch>
        </p:blipFill>
        <p:spPr bwMode="auto">
          <a:xfrm>
            <a:off x="1375467" y="6473604"/>
            <a:ext cx="791889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91" name="Picture 42"/>
          <p:cNvPicPr>
            <a:picLocks noChangeAspect="1" noChangeArrowheads="1"/>
          </p:cNvPicPr>
          <p:nvPr/>
        </p:nvPicPr>
        <p:blipFill>
          <a:blip r:embed="rId21"/>
          <a:srcRect t="50000" r="49872"/>
          <a:stretch>
            <a:fillRect/>
          </a:stretch>
        </p:blipFill>
        <p:spPr bwMode="auto">
          <a:xfrm>
            <a:off x="2186006" y="6473604"/>
            <a:ext cx="791873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92" name="Picture 46"/>
          <p:cNvPicPr>
            <a:picLocks noChangeAspect="1" noChangeArrowheads="1"/>
          </p:cNvPicPr>
          <p:nvPr/>
        </p:nvPicPr>
        <p:blipFill>
          <a:blip r:embed="rId22"/>
          <a:srcRect l="49872" b="50000"/>
          <a:stretch>
            <a:fillRect/>
          </a:stretch>
        </p:blipFill>
        <p:spPr bwMode="auto">
          <a:xfrm>
            <a:off x="4123258" y="6473604"/>
            <a:ext cx="791889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93" name="Picture 48"/>
          <p:cNvPicPr>
            <a:picLocks noChangeAspect="1" noChangeArrowheads="1"/>
          </p:cNvPicPr>
          <p:nvPr/>
        </p:nvPicPr>
        <p:blipFill>
          <a:blip r:embed="rId22"/>
          <a:srcRect t="50000" r="49872"/>
          <a:stretch>
            <a:fillRect/>
          </a:stretch>
        </p:blipFill>
        <p:spPr bwMode="auto">
          <a:xfrm>
            <a:off x="4933562" y="6473604"/>
            <a:ext cx="791860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94" name="Picture 48"/>
          <p:cNvPicPr>
            <a:picLocks noChangeAspect="1" noChangeArrowheads="1"/>
          </p:cNvPicPr>
          <p:nvPr/>
        </p:nvPicPr>
        <p:blipFill>
          <a:blip r:embed="rId22"/>
          <a:srcRect l="49872" t="50000"/>
          <a:stretch>
            <a:fillRect/>
          </a:stretch>
        </p:blipFill>
        <p:spPr bwMode="auto">
          <a:xfrm>
            <a:off x="5739419" y="6473604"/>
            <a:ext cx="791860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95" name="Picture 42"/>
          <p:cNvPicPr>
            <a:picLocks noChangeAspect="1" noChangeArrowheads="1"/>
          </p:cNvPicPr>
          <p:nvPr/>
        </p:nvPicPr>
        <p:blipFill>
          <a:blip r:embed="rId21"/>
          <a:srcRect l="49872" t="50000"/>
          <a:stretch>
            <a:fillRect/>
          </a:stretch>
        </p:blipFill>
        <p:spPr bwMode="auto">
          <a:xfrm>
            <a:off x="2999110" y="6473604"/>
            <a:ext cx="791866" cy="78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6" name="図形グループ 155"/>
          <p:cNvGrpSpPr/>
          <p:nvPr/>
        </p:nvGrpSpPr>
        <p:grpSpPr>
          <a:xfrm>
            <a:off x="1375512" y="5531100"/>
            <a:ext cx="5154753" cy="788788"/>
            <a:chOff x="1375512" y="6018115"/>
            <a:chExt cx="5154753" cy="788788"/>
          </a:xfrm>
        </p:grpSpPr>
        <p:pic>
          <p:nvPicPr>
            <p:cNvPr id="297" name="Picture 38"/>
            <p:cNvPicPr>
              <a:picLocks noChangeAspect="1" noChangeArrowheads="1"/>
            </p:cNvPicPr>
            <p:nvPr/>
          </p:nvPicPr>
          <p:blipFill>
            <a:blip r:embed="rId23"/>
            <a:srcRect l="49877" b="50000"/>
            <a:stretch>
              <a:fillRect/>
            </a:stretch>
          </p:blipFill>
          <p:spPr bwMode="auto">
            <a:xfrm>
              <a:off x="1375512" y="6018115"/>
              <a:ext cx="791799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98" name="Picture 43"/>
            <p:cNvPicPr>
              <a:picLocks noChangeAspect="1" noChangeArrowheads="1"/>
            </p:cNvPicPr>
            <p:nvPr/>
          </p:nvPicPr>
          <p:blipFill>
            <a:blip r:embed="rId24"/>
            <a:srcRect t="50000" r="49872"/>
            <a:stretch>
              <a:fillRect/>
            </a:stretch>
          </p:blipFill>
          <p:spPr bwMode="auto">
            <a:xfrm>
              <a:off x="2186006" y="6018115"/>
              <a:ext cx="791873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99" name="Picture 51"/>
            <p:cNvPicPr>
              <a:picLocks noChangeAspect="1" noChangeArrowheads="1"/>
            </p:cNvPicPr>
            <p:nvPr/>
          </p:nvPicPr>
          <p:blipFill>
            <a:blip r:embed="rId25"/>
            <a:srcRect/>
            <a:stretch>
              <a:fillRect/>
            </a:stretch>
          </p:blipFill>
          <p:spPr bwMode="auto">
            <a:xfrm>
              <a:off x="4124285" y="6018115"/>
              <a:ext cx="789834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00" name="Picture 50"/>
            <p:cNvPicPr>
              <a:picLocks noChangeAspect="1" noChangeArrowheads="1"/>
            </p:cNvPicPr>
            <p:nvPr/>
          </p:nvPicPr>
          <p:blipFill>
            <a:blip r:embed="rId26"/>
            <a:srcRect/>
            <a:stretch>
              <a:fillRect/>
            </a:stretch>
          </p:blipFill>
          <p:spPr bwMode="auto">
            <a:xfrm>
              <a:off x="4934575" y="6018115"/>
              <a:ext cx="789834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01" name="Picture 49"/>
            <p:cNvPicPr>
              <a:picLocks noChangeAspect="1" noChangeArrowheads="1"/>
            </p:cNvPicPr>
            <p:nvPr/>
          </p:nvPicPr>
          <p:blipFill>
            <a:blip r:embed="rId27"/>
            <a:srcRect/>
            <a:stretch>
              <a:fillRect/>
            </a:stretch>
          </p:blipFill>
          <p:spPr bwMode="auto">
            <a:xfrm>
              <a:off x="5740431" y="6018115"/>
              <a:ext cx="789834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02" name="Picture 43"/>
            <p:cNvPicPr>
              <a:picLocks noChangeAspect="1" noChangeArrowheads="1"/>
            </p:cNvPicPr>
            <p:nvPr/>
          </p:nvPicPr>
          <p:blipFill>
            <a:blip r:embed="rId24"/>
            <a:srcRect l="49872" t="50000"/>
            <a:stretch>
              <a:fillRect/>
            </a:stretch>
          </p:blipFill>
          <p:spPr bwMode="auto">
            <a:xfrm>
              <a:off x="2999110" y="6018115"/>
              <a:ext cx="791866" cy="788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303" name="テキスト ボックス 302"/>
          <p:cNvSpPr txBox="1"/>
          <p:nvPr/>
        </p:nvSpPr>
        <p:spPr>
          <a:xfrm rot="16200000">
            <a:off x="1005530" y="7557964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 rot="16200000">
            <a:off x="1044004" y="6745288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05" name="テキスト ボックス 304"/>
          <p:cNvSpPr txBox="1"/>
          <p:nvPr/>
        </p:nvSpPr>
        <p:spPr>
          <a:xfrm rot="16200000">
            <a:off x="3765725" y="7557964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 rot="16200000">
            <a:off x="3804197" y="6745288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cxnSp>
        <p:nvCxnSpPr>
          <p:cNvPr id="307" name="直線コネクタ 306"/>
          <p:cNvCxnSpPr/>
          <p:nvPr/>
        </p:nvCxnSpPr>
        <p:spPr>
          <a:xfrm>
            <a:off x="1277753" y="7273584"/>
            <a:ext cx="2563455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8" name="直線コネクタ 307"/>
          <p:cNvCxnSpPr/>
          <p:nvPr/>
        </p:nvCxnSpPr>
        <p:spPr>
          <a:xfrm>
            <a:off x="1277753" y="6466254"/>
            <a:ext cx="2563455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9" name="直線コネクタ 308"/>
          <p:cNvCxnSpPr/>
          <p:nvPr/>
        </p:nvCxnSpPr>
        <p:spPr>
          <a:xfrm rot="5400000" flipH="1" flipV="1">
            <a:off x="498704" y="6310088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0" name="直線コネクタ 309"/>
          <p:cNvCxnSpPr/>
          <p:nvPr/>
        </p:nvCxnSpPr>
        <p:spPr>
          <a:xfrm rot="5400000" flipH="1" flipV="1">
            <a:off x="1313936" y="6310088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1" name="直線コネクタ 310"/>
          <p:cNvCxnSpPr/>
          <p:nvPr/>
        </p:nvCxnSpPr>
        <p:spPr>
          <a:xfrm>
            <a:off x="4024844" y="7273584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2" name="直線コネクタ 311"/>
          <p:cNvCxnSpPr/>
          <p:nvPr/>
        </p:nvCxnSpPr>
        <p:spPr>
          <a:xfrm rot="5400000" flipH="1" flipV="1">
            <a:off x="3245795" y="6310088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3" name="直線コネクタ 312"/>
          <p:cNvCxnSpPr/>
          <p:nvPr/>
        </p:nvCxnSpPr>
        <p:spPr>
          <a:xfrm rot="5400000" flipH="1" flipV="1">
            <a:off x="4061026" y="6310088"/>
            <a:ext cx="3352226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4" name="直線コネクタ 313"/>
          <p:cNvCxnSpPr/>
          <p:nvPr/>
        </p:nvCxnSpPr>
        <p:spPr>
          <a:xfrm>
            <a:off x="4024844" y="6466254"/>
            <a:ext cx="2563454" cy="1866"/>
          </a:xfrm>
          <a:prstGeom prst="line">
            <a:avLst/>
          </a:prstGeom>
          <a:ln w="19050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5" name="テキスト ボックス 314"/>
          <p:cNvSpPr txBox="1"/>
          <p:nvPr/>
        </p:nvSpPr>
        <p:spPr>
          <a:xfrm rot="16200000">
            <a:off x="1005531" y="5808966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16" name="テキスト ボックス 315"/>
          <p:cNvSpPr txBox="1"/>
          <p:nvPr/>
        </p:nvSpPr>
        <p:spPr>
          <a:xfrm rot="16200000">
            <a:off x="1044005" y="4996290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17" name="テキスト ボックス 316"/>
          <p:cNvSpPr txBox="1"/>
          <p:nvPr/>
        </p:nvSpPr>
        <p:spPr>
          <a:xfrm rot="16200000">
            <a:off x="3765726" y="5808966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18" name="テキスト ボックス 317"/>
          <p:cNvSpPr txBox="1"/>
          <p:nvPr/>
        </p:nvSpPr>
        <p:spPr>
          <a:xfrm rot="16200000">
            <a:off x="3804198" y="4996290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19" name="テキスト ボックス 318"/>
          <p:cNvSpPr txBox="1"/>
          <p:nvPr/>
        </p:nvSpPr>
        <p:spPr>
          <a:xfrm rot="16200000">
            <a:off x="1005531" y="3712377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0" name="テキスト ボックス 319"/>
          <p:cNvSpPr txBox="1"/>
          <p:nvPr/>
        </p:nvSpPr>
        <p:spPr>
          <a:xfrm rot="16200000">
            <a:off x="1044005" y="2899701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1" name="テキスト ボックス 320"/>
          <p:cNvSpPr txBox="1"/>
          <p:nvPr/>
        </p:nvSpPr>
        <p:spPr>
          <a:xfrm rot="16200000">
            <a:off x="3765726" y="3712377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2" name="テキスト ボックス 321"/>
          <p:cNvSpPr txBox="1"/>
          <p:nvPr/>
        </p:nvSpPr>
        <p:spPr>
          <a:xfrm rot="16200000">
            <a:off x="3804198" y="2899701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3" name="テキスト ボックス 322"/>
          <p:cNvSpPr txBox="1"/>
          <p:nvPr/>
        </p:nvSpPr>
        <p:spPr>
          <a:xfrm rot="16200000">
            <a:off x="1005532" y="1963379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4" name="テキスト ボックス 323"/>
          <p:cNvSpPr txBox="1"/>
          <p:nvPr/>
        </p:nvSpPr>
        <p:spPr>
          <a:xfrm rot="16200000">
            <a:off x="1044006" y="1150703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5" name="テキスト ボックス 324"/>
          <p:cNvSpPr txBox="1"/>
          <p:nvPr/>
        </p:nvSpPr>
        <p:spPr>
          <a:xfrm rot="16200000">
            <a:off x="3765727" y="1963379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 rot="16200000">
            <a:off x="3804199" y="1150703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PL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3782163" y="432788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328" name="テキスト ボックス 327"/>
          <p:cNvSpPr txBox="1"/>
          <p:nvPr/>
        </p:nvSpPr>
        <p:spPr>
          <a:xfrm>
            <a:off x="1024836" y="427543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c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329" name="テキスト ボックス 328"/>
          <p:cNvSpPr txBox="1"/>
          <p:nvPr/>
        </p:nvSpPr>
        <p:spPr>
          <a:xfrm>
            <a:off x="3782163" y="4275431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d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330" name="正方形/長方形 329"/>
          <p:cNvSpPr/>
          <p:nvPr/>
        </p:nvSpPr>
        <p:spPr>
          <a:xfrm>
            <a:off x="1331728" y="839577"/>
            <a:ext cx="2502000" cy="1677600"/>
          </a:xfrm>
          <a:prstGeom prst="rect">
            <a:avLst/>
          </a:prstGeom>
          <a:noFill/>
          <a:ln w="12700" cap="flat" cmpd="sng" algn="ctr">
            <a:solidFill>
              <a:schemeClr val="tx2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1" name="正方形/長方形 330"/>
          <p:cNvSpPr/>
          <p:nvPr/>
        </p:nvSpPr>
        <p:spPr>
          <a:xfrm>
            <a:off x="4077328" y="839577"/>
            <a:ext cx="2502000" cy="1677600"/>
          </a:xfrm>
          <a:prstGeom prst="rect">
            <a:avLst/>
          </a:prstGeom>
          <a:noFill/>
          <a:ln w="12700" cap="flat" cmpd="sng" algn="ctr">
            <a:solidFill>
              <a:schemeClr val="tx2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2" name="正方形/長方形 331"/>
          <p:cNvSpPr/>
          <p:nvPr/>
        </p:nvSpPr>
        <p:spPr>
          <a:xfrm>
            <a:off x="1331728" y="4683176"/>
            <a:ext cx="2502000" cy="1677600"/>
          </a:xfrm>
          <a:prstGeom prst="rect">
            <a:avLst/>
          </a:prstGeom>
          <a:noFill/>
          <a:ln w="12700" cap="flat" cmpd="sng" algn="ctr">
            <a:solidFill>
              <a:schemeClr val="tx2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3" name="正方形/長方形 332"/>
          <p:cNvSpPr/>
          <p:nvPr/>
        </p:nvSpPr>
        <p:spPr>
          <a:xfrm>
            <a:off x="4077328" y="4683176"/>
            <a:ext cx="2502000" cy="1677600"/>
          </a:xfrm>
          <a:prstGeom prst="rect">
            <a:avLst/>
          </a:prstGeom>
          <a:noFill/>
          <a:ln w="12700" cap="flat" cmpd="sng" algn="ctr">
            <a:solidFill>
              <a:schemeClr val="tx2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4" name="正方形/長方形 333"/>
          <p:cNvSpPr/>
          <p:nvPr/>
        </p:nvSpPr>
        <p:spPr>
          <a:xfrm>
            <a:off x="1331728" y="6436292"/>
            <a:ext cx="2502000" cy="1677600"/>
          </a:xfrm>
          <a:prstGeom prst="rect">
            <a:avLst/>
          </a:prstGeom>
          <a:noFill/>
          <a:ln w="12700" cap="flat" cmpd="sng" algn="ctr">
            <a:solidFill>
              <a:srgbClr val="00009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5" name="正方形/長方形 334"/>
          <p:cNvSpPr/>
          <p:nvPr/>
        </p:nvSpPr>
        <p:spPr>
          <a:xfrm>
            <a:off x="4077328" y="6436292"/>
            <a:ext cx="2502000" cy="1677600"/>
          </a:xfrm>
          <a:prstGeom prst="rect">
            <a:avLst/>
          </a:prstGeom>
          <a:noFill/>
          <a:ln w="12700" cap="flat" cmpd="sng" algn="ctr">
            <a:solidFill>
              <a:srgbClr val="00009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6" name="正方形/長方形 335"/>
          <p:cNvSpPr/>
          <p:nvPr/>
        </p:nvSpPr>
        <p:spPr>
          <a:xfrm>
            <a:off x="1331728" y="2588913"/>
            <a:ext cx="2502000" cy="1677600"/>
          </a:xfrm>
          <a:prstGeom prst="rect">
            <a:avLst/>
          </a:prstGeom>
          <a:noFill/>
          <a:ln w="12700" cap="flat" cmpd="sng" algn="ctr">
            <a:solidFill>
              <a:srgbClr val="00009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37" name="正方形/長方形 336"/>
          <p:cNvSpPr/>
          <p:nvPr/>
        </p:nvSpPr>
        <p:spPr>
          <a:xfrm>
            <a:off x="4077328" y="2588913"/>
            <a:ext cx="2502000" cy="1677600"/>
          </a:xfrm>
          <a:prstGeom prst="rect">
            <a:avLst/>
          </a:prstGeom>
          <a:noFill/>
          <a:ln w="12700" cap="flat" cmpd="sng" algn="ctr">
            <a:solidFill>
              <a:srgbClr val="00009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8" name="テキスト ボックス 337"/>
          <p:cNvSpPr txBox="1"/>
          <p:nvPr/>
        </p:nvSpPr>
        <p:spPr>
          <a:xfrm>
            <a:off x="247020" y="494371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M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>
            <a:off x="225952" y="5155980"/>
            <a:ext cx="2616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H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40" name="フリーフォーム 339"/>
          <p:cNvSpPr/>
          <p:nvPr/>
        </p:nvSpPr>
        <p:spPr>
          <a:xfrm>
            <a:off x="250902" y="5150368"/>
            <a:ext cx="772439" cy="247140"/>
          </a:xfrm>
          <a:custGeom>
            <a:avLst/>
            <a:gdLst>
              <a:gd name="connsiteX0" fmla="*/ 102695 w 2816763"/>
              <a:gd name="connsiteY0" fmla="*/ 2096 h 901213"/>
              <a:gd name="connsiteX1" fmla="*/ 505089 w 2816763"/>
              <a:gd name="connsiteY1" fmla="*/ 52396 h 901213"/>
              <a:gd name="connsiteX2" fmla="*/ 1146406 w 2816763"/>
              <a:gd name="connsiteY2" fmla="*/ 228447 h 901213"/>
              <a:gd name="connsiteX3" fmla="*/ 1712273 w 2816763"/>
              <a:gd name="connsiteY3" fmla="*/ 316473 h 901213"/>
              <a:gd name="connsiteX4" fmla="*/ 2014069 w 2816763"/>
              <a:gd name="connsiteY4" fmla="*/ 329048 h 901213"/>
              <a:gd name="connsiteX5" fmla="*/ 2378740 w 2816763"/>
              <a:gd name="connsiteY5" fmla="*/ 241022 h 901213"/>
              <a:gd name="connsiteX6" fmla="*/ 2617661 w 2816763"/>
              <a:gd name="connsiteY6" fmla="*/ 152997 h 901213"/>
              <a:gd name="connsiteX7" fmla="*/ 2755985 w 2816763"/>
              <a:gd name="connsiteY7" fmla="*/ 203297 h 901213"/>
              <a:gd name="connsiteX8" fmla="*/ 2755985 w 2816763"/>
              <a:gd name="connsiteY8" fmla="*/ 366773 h 901213"/>
              <a:gd name="connsiteX9" fmla="*/ 2391314 w 2816763"/>
              <a:gd name="connsiteY9" fmla="*/ 655999 h 901213"/>
              <a:gd name="connsiteX10" fmla="*/ 1787722 w 2816763"/>
              <a:gd name="connsiteY10" fmla="*/ 806900 h 901213"/>
              <a:gd name="connsiteX11" fmla="*/ 1158981 w 2816763"/>
              <a:gd name="connsiteY11" fmla="*/ 731449 h 901213"/>
              <a:gd name="connsiteX12" fmla="*/ 643413 w 2816763"/>
              <a:gd name="connsiteY12" fmla="*/ 731449 h 901213"/>
              <a:gd name="connsiteX13" fmla="*/ 190719 w 2816763"/>
              <a:gd name="connsiteY13" fmla="*/ 819475 h 901213"/>
              <a:gd name="connsiteX14" fmla="*/ 39821 w 2816763"/>
              <a:gd name="connsiteY14" fmla="*/ 882350 h 901213"/>
              <a:gd name="connsiteX15" fmla="*/ 52395 w 2816763"/>
              <a:gd name="connsiteY15" fmla="*/ 706299 h 901213"/>
              <a:gd name="connsiteX16" fmla="*/ 354191 w 2816763"/>
              <a:gd name="connsiteY16" fmla="*/ 605699 h 901213"/>
              <a:gd name="connsiteX17" fmla="*/ 832035 w 2816763"/>
              <a:gd name="connsiteY17" fmla="*/ 580549 h 901213"/>
              <a:gd name="connsiteX18" fmla="*/ 1284729 w 2816763"/>
              <a:gd name="connsiteY18" fmla="*/ 630849 h 901213"/>
              <a:gd name="connsiteX19" fmla="*/ 1749998 w 2816763"/>
              <a:gd name="connsiteY19" fmla="*/ 630849 h 901213"/>
              <a:gd name="connsiteX20" fmla="*/ 1963770 w 2816763"/>
              <a:gd name="connsiteY20" fmla="*/ 593124 h 901213"/>
              <a:gd name="connsiteX21" fmla="*/ 2315865 w 2816763"/>
              <a:gd name="connsiteY21" fmla="*/ 467373 h 901213"/>
              <a:gd name="connsiteX22" fmla="*/ 2429039 w 2816763"/>
              <a:gd name="connsiteY22" fmla="*/ 417073 h 901213"/>
              <a:gd name="connsiteX23" fmla="*/ 2164967 w 2816763"/>
              <a:gd name="connsiteY23" fmla="*/ 479948 h 901213"/>
              <a:gd name="connsiteX24" fmla="*/ 1825447 w 2816763"/>
              <a:gd name="connsiteY24" fmla="*/ 530249 h 901213"/>
              <a:gd name="connsiteX25" fmla="*/ 1309879 w 2816763"/>
              <a:gd name="connsiteY25" fmla="*/ 442223 h 901213"/>
              <a:gd name="connsiteX26" fmla="*/ 718862 w 2816763"/>
              <a:gd name="connsiteY26" fmla="*/ 316473 h 901213"/>
              <a:gd name="connsiteX27" fmla="*/ 404491 w 2816763"/>
              <a:gd name="connsiteY27" fmla="*/ 215872 h 901213"/>
              <a:gd name="connsiteX28" fmla="*/ 102695 w 2816763"/>
              <a:gd name="connsiteY28" fmla="*/ 215872 h 901213"/>
              <a:gd name="connsiteX29" fmla="*/ 14671 w 2816763"/>
              <a:gd name="connsiteY29" fmla="*/ 215872 h 901213"/>
              <a:gd name="connsiteX30" fmla="*/ 27246 w 2816763"/>
              <a:gd name="connsiteY30" fmla="*/ 39821 h 901213"/>
              <a:gd name="connsiteX31" fmla="*/ 102695 w 2816763"/>
              <a:gd name="connsiteY31" fmla="*/ 2096 h 9012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2816763" h="901213">
                <a:moveTo>
                  <a:pt x="102695" y="2096"/>
                </a:moveTo>
                <a:cubicBezTo>
                  <a:pt x="182335" y="4192"/>
                  <a:pt x="331137" y="14671"/>
                  <a:pt x="505089" y="52396"/>
                </a:cubicBezTo>
                <a:cubicBezTo>
                  <a:pt x="679041" y="90121"/>
                  <a:pt x="945209" y="184434"/>
                  <a:pt x="1146406" y="228447"/>
                </a:cubicBezTo>
                <a:cubicBezTo>
                  <a:pt x="1347603" y="272460"/>
                  <a:pt x="1567663" y="299706"/>
                  <a:pt x="1712273" y="316473"/>
                </a:cubicBezTo>
                <a:cubicBezTo>
                  <a:pt x="1856883" y="333240"/>
                  <a:pt x="1902991" y="341623"/>
                  <a:pt x="2014069" y="329048"/>
                </a:cubicBezTo>
                <a:cubicBezTo>
                  <a:pt x="2125147" y="316473"/>
                  <a:pt x="2278141" y="270364"/>
                  <a:pt x="2378740" y="241022"/>
                </a:cubicBezTo>
                <a:cubicBezTo>
                  <a:pt x="2479339" y="211680"/>
                  <a:pt x="2554787" y="159284"/>
                  <a:pt x="2617661" y="152997"/>
                </a:cubicBezTo>
                <a:cubicBezTo>
                  <a:pt x="2680535" y="146710"/>
                  <a:pt x="2732931" y="167668"/>
                  <a:pt x="2755985" y="203297"/>
                </a:cubicBezTo>
                <a:cubicBezTo>
                  <a:pt x="2779039" y="238926"/>
                  <a:pt x="2816763" y="291323"/>
                  <a:pt x="2755985" y="366773"/>
                </a:cubicBezTo>
                <a:cubicBezTo>
                  <a:pt x="2695207" y="442223"/>
                  <a:pt x="2552691" y="582645"/>
                  <a:pt x="2391314" y="655999"/>
                </a:cubicBezTo>
                <a:cubicBezTo>
                  <a:pt x="2229937" y="729354"/>
                  <a:pt x="1993111" y="794325"/>
                  <a:pt x="1787722" y="806900"/>
                </a:cubicBezTo>
                <a:cubicBezTo>
                  <a:pt x="1582333" y="819475"/>
                  <a:pt x="1349699" y="744024"/>
                  <a:pt x="1158981" y="731449"/>
                </a:cubicBezTo>
                <a:cubicBezTo>
                  <a:pt x="968263" y="718874"/>
                  <a:pt x="804790" y="716778"/>
                  <a:pt x="643413" y="731449"/>
                </a:cubicBezTo>
                <a:cubicBezTo>
                  <a:pt x="482036" y="746120"/>
                  <a:pt x="291318" y="794325"/>
                  <a:pt x="190719" y="819475"/>
                </a:cubicBezTo>
                <a:cubicBezTo>
                  <a:pt x="90120" y="844625"/>
                  <a:pt x="62875" y="901213"/>
                  <a:pt x="39821" y="882350"/>
                </a:cubicBezTo>
                <a:cubicBezTo>
                  <a:pt x="16767" y="863487"/>
                  <a:pt x="0" y="752407"/>
                  <a:pt x="52395" y="706299"/>
                </a:cubicBezTo>
                <a:cubicBezTo>
                  <a:pt x="104790" y="660191"/>
                  <a:pt x="224251" y="626657"/>
                  <a:pt x="354191" y="605699"/>
                </a:cubicBezTo>
                <a:cubicBezTo>
                  <a:pt x="484131" y="584741"/>
                  <a:pt x="676945" y="576357"/>
                  <a:pt x="832035" y="580549"/>
                </a:cubicBezTo>
                <a:cubicBezTo>
                  <a:pt x="987125" y="584741"/>
                  <a:pt x="1131735" y="622466"/>
                  <a:pt x="1284729" y="630849"/>
                </a:cubicBezTo>
                <a:cubicBezTo>
                  <a:pt x="1437723" y="639232"/>
                  <a:pt x="1636824" y="637137"/>
                  <a:pt x="1749998" y="630849"/>
                </a:cubicBezTo>
                <a:cubicBezTo>
                  <a:pt x="1863172" y="624561"/>
                  <a:pt x="1869459" y="620370"/>
                  <a:pt x="1963770" y="593124"/>
                </a:cubicBezTo>
                <a:cubicBezTo>
                  <a:pt x="2058081" y="565878"/>
                  <a:pt x="2238320" y="496715"/>
                  <a:pt x="2315865" y="467373"/>
                </a:cubicBezTo>
                <a:cubicBezTo>
                  <a:pt x="2393410" y="438031"/>
                  <a:pt x="2454189" y="414977"/>
                  <a:pt x="2429039" y="417073"/>
                </a:cubicBezTo>
                <a:cubicBezTo>
                  <a:pt x="2403889" y="419169"/>
                  <a:pt x="2265566" y="461085"/>
                  <a:pt x="2164967" y="479948"/>
                </a:cubicBezTo>
                <a:cubicBezTo>
                  <a:pt x="2064368" y="498811"/>
                  <a:pt x="1967962" y="536536"/>
                  <a:pt x="1825447" y="530249"/>
                </a:cubicBezTo>
                <a:cubicBezTo>
                  <a:pt x="1682932" y="523962"/>
                  <a:pt x="1494310" y="477852"/>
                  <a:pt x="1309879" y="442223"/>
                </a:cubicBezTo>
                <a:cubicBezTo>
                  <a:pt x="1125448" y="406594"/>
                  <a:pt x="869760" y="354198"/>
                  <a:pt x="718862" y="316473"/>
                </a:cubicBezTo>
                <a:cubicBezTo>
                  <a:pt x="567964" y="278748"/>
                  <a:pt x="507186" y="232639"/>
                  <a:pt x="404491" y="215872"/>
                </a:cubicBezTo>
                <a:cubicBezTo>
                  <a:pt x="301797" y="199105"/>
                  <a:pt x="102695" y="215872"/>
                  <a:pt x="102695" y="215872"/>
                </a:cubicBezTo>
                <a:cubicBezTo>
                  <a:pt x="37725" y="215872"/>
                  <a:pt x="27246" y="245214"/>
                  <a:pt x="14671" y="215872"/>
                </a:cubicBezTo>
                <a:cubicBezTo>
                  <a:pt x="2096" y="186530"/>
                  <a:pt x="10480" y="73354"/>
                  <a:pt x="27246" y="39821"/>
                </a:cubicBezTo>
                <a:cubicBezTo>
                  <a:pt x="44012" y="6288"/>
                  <a:pt x="23055" y="0"/>
                  <a:pt x="102695" y="2096"/>
                </a:cubicBezTo>
                <a:close/>
              </a:path>
            </a:pathLst>
          </a:custGeom>
          <a:solidFill>
            <a:schemeClr val="bg1">
              <a:lumMod val="75000"/>
            </a:schemeClr>
          </a:solidFill>
          <a:ln w="9525" cap="flat" cmpd="sng" algn="ctr">
            <a:solidFill>
              <a:srgbClr val="00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1" name="正方形/長方形 340"/>
          <p:cNvSpPr/>
          <p:nvPr/>
        </p:nvSpPr>
        <p:spPr>
          <a:xfrm>
            <a:off x="182509" y="4828799"/>
            <a:ext cx="109014" cy="6431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2" name="フリーフォーム 341"/>
          <p:cNvSpPr/>
          <p:nvPr/>
        </p:nvSpPr>
        <p:spPr>
          <a:xfrm>
            <a:off x="293700" y="4956411"/>
            <a:ext cx="769680" cy="189228"/>
          </a:xfrm>
          <a:custGeom>
            <a:avLst/>
            <a:gdLst>
              <a:gd name="connsiteX0" fmla="*/ 0 w 2806700"/>
              <a:gd name="connsiteY0" fmla="*/ 0 h 690034"/>
              <a:gd name="connsiteX1" fmla="*/ 461434 w 2806700"/>
              <a:gd name="connsiteY1" fmla="*/ 59267 h 690034"/>
              <a:gd name="connsiteX2" fmla="*/ 1032934 w 2806700"/>
              <a:gd name="connsiteY2" fmla="*/ 152400 h 690034"/>
              <a:gd name="connsiteX3" fmla="*/ 1642534 w 2806700"/>
              <a:gd name="connsiteY3" fmla="*/ 304800 h 690034"/>
              <a:gd name="connsiteX4" fmla="*/ 2146300 w 2806700"/>
              <a:gd name="connsiteY4" fmla="*/ 419100 h 690034"/>
              <a:gd name="connsiteX5" fmla="*/ 2628900 w 2806700"/>
              <a:gd name="connsiteY5" fmla="*/ 554567 h 690034"/>
              <a:gd name="connsiteX6" fmla="*/ 2768600 w 2806700"/>
              <a:gd name="connsiteY6" fmla="*/ 622300 h 690034"/>
              <a:gd name="connsiteX7" fmla="*/ 2806700 w 2806700"/>
              <a:gd name="connsiteY7" fmla="*/ 690034 h 6900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2806700" h="690034">
                <a:moveTo>
                  <a:pt x="0" y="0"/>
                </a:moveTo>
                <a:cubicBezTo>
                  <a:pt x="144639" y="16933"/>
                  <a:pt x="289278" y="33867"/>
                  <a:pt x="461434" y="59267"/>
                </a:cubicBezTo>
                <a:cubicBezTo>
                  <a:pt x="633590" y="84667"/>
                  <a:pt x="836084" y="111478"/>
                  <a:pt x="1032934" y="152400"/>
                </a:cubicBezTo>
                <a:cubicBezTo>
                  <a:pt x="1229784" y="193322"/>
                  <a:pt x="1456973" y="260350"/>
                  <a:pt x="1642534" y="304800"/>
                </a:cubicBezTo>
                <a:cubicBezTo>
                  <a:pt x="1828095" y="349250"/>
                  <a:pt x="1981906" y="377472"/>
                  <a:pt x="2146300" y="419100"/>
                </a:cubicBezTo>
                <a:cubicBezTo>
                  <a:pt x="2310694" y="460728"/>
                  <a:pt x="2525183" y="520700"/>
                  <a:pt x="2628900" y="554567"/>
                </a:cubicBezTo>
                <a:cubicBezTo>
                  <a:pt x="2732617" y="588434"/>
                  <a:pt x="2738967" y="599722"/>
                  <a:pt x="2768600" y="622300"/>
                </a:cubicBezTo>
                <a:cubicBezTo>
                  <a:pt x="2798233" y="644878"/>
                  <a:pt x="2802466" y="667456"/>
                  <a:pt x="2806700" y="690034"/>
                </a:cubicBezTo>
              </a:path>
            </a:pathLst>
          </a:custGeom>
          <a:ln w="9525" cap="flat" cmpd="sng" algn="ctr">
            <a:solidFill>
              <a:srgbClr val="00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3" name="フリーフォーム 342"/>
          <p:cNvSpPr/>
          <p:nvPr/>
        </p:nvSpPr>
        <p:spPr>
          <a:xfrm>
            <a:off x="904335" y="5380142"/>
            <a:ext cx="160205" cy="119573"/>
          </a:xfrm>
          <a:custGeom>
            <a:avLst/>
            <a:gdLst>
              <a:gd name="connsiteX0" fmla="*/ 584200 w 584200"/>
              <a:gd name="connsiteY0" fmla="*/ 0 h 436033"/>
              <a:gd name="connsiteX1" fmla="*/ 431800 w 584200"/>
              <a:gd name="connsiteY1" fmla="*/ 190500 h 436033"/>
              <a:gd name="connsiteX2" fmla="*/ 148167 w 584200"/>
              <a:gd name="connsiteY2" fmla="*/ 376767 h 436033"/>
              <a:gd name="connsiteX3" fmla="*/ 0 w 584200"/>
              <a:gd name="connsiteY3" fmla="*/ 436033 h 4360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84200" h="436033">
                <a:moveTo>
                  <a:pt x="584200" y="0"/>
                </a:moveTo>
                <a:cubicBezTo>
                  <a:pt x="544336" y="63853"/>
                  <a:pt x="504472" y="127706"/>
                  <a:pt x="431800" y="190500"/>
                </a:cubicBezTo>
                <a:cubicBezTo>
                  <a:pt x="359128" y="253294"/>
                  <a:pt x="220134" y="335845"/>
                  <a:pt x="148167" y="376767"/>
                </a:cubicBezTo>
                <a:cubicBezTo>
                  <a:pt x="76200" y="417689"/>
                  <a:pt x="38100" y="426861"/>
                  <a:pt x="0" y="436033"/>
                </a:cubicBezTo>
              </a:path>
            </a:pathLst>
          </a:custGeom>
          <a:ln w="9525" cap="flat" cmpd="sng" algn="ctr">
            <a:solidFill>
              <a:srgbClr val="00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4" name="正方形/長方形 343"/>
          <p:cNvSpPr/>
          <p:nvPr/>
        </p:nvSpPr>
        <p:spPr>
          <a:xfrm>
            <a:off x="291523" y="4729743"/>
            <a:ext cx="773496" cy="771483"/>
          </a:xfrm>
          <a:prstGeom prst="rect">
            <a:avLst/>
          </a:prstGeom>
          <a:noFill/>
          <a:ln w="12700" cap="flat" cmpd="sng" algn="ctr">
            <a:solidFill>
              <a:schemeClr val="tx2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5" name="テキスト ボックス 344"/>
          <p:cNvSpPr txBox="1"/>
          <p:nvPr/>
        </p:nvSpPr>
        <p:spPr>
          <a:xfrm>
            <a:off x="416297" y="509870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GC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46" name="フリーフォーム 345"/>
          <p:cNvSpPr/>
          <p:nvPr/>
        </p:nvSpPr>
        <p:spPr>
          <a:xfrm>
            <a:off x="254925" y="6814353"/>
            <a:ext cx="478751" cy="466692"/>
          </a:xfrm>
          <a:custGeom>
            <a:avLst/>
            <a:gdLst>
              <a:gd name="connsiteX0" fmla="*/ 125748 w 1745806"/>
              <a:gd name="connsiteY0" fmla="*/ 85929 h 1701824"/>
              <a:gd name="connsiteX1" fmla="*/ 804789 w 1745806"/>
              <a:gd name="connsiteY1" fmla="*/ 676956 h 1701824"/>
              <a:gd name="connsiteX2" fmla="*/ 1257483 w 1745806"/>
              <a:gd name="connsiteY2" fmla="*/ 1066783 h 1701824"/>
              <a:gd name="connsiteX3" fmla="*/ 1584429 w 1745806"/>
              <a:gd name="connsiteY3" fmla="*/ 1418885 h 1701824"/>
              <a:gd name="connsiteX4" fmla="*/ 1722752 w 1745806"/>
              <a:gd name="connsiteY4" fmla="*/ 1657811 h 1701824"/>
              <a:gd name="connsiteX5" fmla="*/ 1559279 w 1745806"/>
              <a:gd name="connsiteY5" fmla="*/ 1682961 h 1701824"/>
              <a:gd name="connsiteX6" fmla="*/ 603592 w 1745806"/>
              <a:gd name="connsiteY6" fmla="*/ 1657811 h 1701824"/>
              <a:gd name="connsiteX7" fmla="*/ 528143 w 1745806"/>
              <a:gd name="connsiteY7" fmla="*/ 1569785 h 1701824"/>
              <a:gd name="connsiteX8" fmla="*/ 264071 w 1745806"/>
              <a:gd name="connsiteY8" fmla="*/ 1205109 h 1701824"/>
              <a:gd name="connsiteX9" fmla="*/ 37724 w 1745806"/>
              <a:gd name="connsiteY9" fmla="*/ 1041633 h 1701824"/>
              <a:gd name="connsiteX10" fmla="*/ 37724 w 1745806"/>
              <a:gd name="connsiteY10" fmla="*/ 890732 h 1701824"/>
              <a:gd name="connsiteX11" fmla="*/ 37724 w 1745806"/>
              <a:gd name="connsiteY11" fmla="*/ 186529 h 1701824"/>
              <a:gd name="connsiteX12" fmla="*/ 125748 w 1745806"/>
              <a:gd name="connsiteY12" fmla="*/ 161379 h 1701824"/>
              <a:gd name="connsiteX13" fmla="*/ 125748 w 1745806"/>
              <a:gd name="connsiteY13" fmla="*/ 85929 h 17018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1745806" h="1701824">
                <a:moveTo>
                  <a:pt x="125748" y="85929"/>
                </a:moveTo>
                <a:cubicBezTo>
                  <a:pt x="238921" y="171858"/>
                  <a:pt x="804789" y="676956"/>
                  <a:pt x="804789" y="676956"/>
                </a:cubicBezTo>
                <a:cubicBezTo>
                  <a:pt x="993411" y="840432"/>
                  <a:pt x="1127543" y="943128"/>
                  <a:pt x="1257483" y="1066783"/>
                </a:cubicBezTo>
                <a:cubicBezTo>
                  <a:pt x="1387423" y="1190438"/>
                  <a:pt x="1506884" y="1320380"/>
                  <a:pt x="1584429" y="1418885"/>
                </a:cubicBezTo>
                <a:cubicBezTo>
                  <a:pt x="1661974" y="1517390"/>
                  <a:pt x="1726944" y="1613798"/>
                  <a:pt x="1722752" y="1657811"/>
                </a:cubicBezTo>
                <a:cubicBezTo>
                  <a:pt x="1718560" y="1701824"/>
                  <a:pt x="1745806" y="1682961"/>
                  <a:pt x="1559279" y="1682961"/>
                </a:cubicBezTo>
                <a:cubicBezTo>
                  <a:pt x="1372752" y="1682961"/>
                  <a:pt x="775448" y="1676674"/>
                  <a:pt x="603592" y="1657811"/>
                </a:cubicBezTo>
                <a:cubicBezTo>
                  <a:pt x="431736" y="1638948"/>
                  <a:pt x="584730" y="1645235"/>
                  <a:pt x="528143" y="1569785"/>
                </a:cubicBezTo>
                <a:cubicBezTo>
                  <a:pt x="471556" y="1494335"/>
                  <a:pt x="345807" y="1293134"/>
                  <a:pt x="264071" y="1205109"/>
                </a:cubicBezTo>
                <a:cubicBezTo>
                  <a:pt x="182335" y="1117084"/>
                  <a:pt x="75448" y="1094029"/>
                  <a:pt x="37724" y="1041633"/>
                </a:cubicBezTo>
                <a:cubicBezTo>
                  <a:pt x="0" y="989237"/>
                  <a:pt x="37724" y="890732"/>
                  <a:pt x="37724" y="890732"/>
                </a:cubicBezTo>
                <a:cubicBezTo>
                  <a:pt x="37724" y="748215"/>
                  <a:pt x="23053" y="308088"/>
                  <a:pt x="37724" y="186529"/>
                </a:cubicBezTo>
                <a:cubicBezTo>
                  <a:pt x="52395" y="64970"/>
                  <a:pt x="106886" y="173954"/>
                  <a:pt x="125748" y="161379"/>
                </a:cubicBezTo>
                <a:cubicBezTo>
                  <a:pt x="144610" y="148804"/>
                  <a:pt x="12575" y="0"/>
                  <a:pt x="125748" y="85929"/>
                </a:cubicBezTo>
                <a:close/>
              </a:path>
            </a:pathLst>
          </a:custGeom>
          <a:solidFill>
            <a:schemeClr val="bg1">
              <a:lumMod val="75000"/>
            </a:schemeClr>
          </a:solidFill>
          <a:ln w="12700" cap="flat" cmpd="sng" algn="ctr">
            <a:solidFill>
              <a:schemeClr val="tx1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7" name="正方形/長方形 346"/>
          <p:cNvSpPr/>
          <p:nvPr/>
        </p:nvSpPr>
        <p:spPr>
          <a:xfrm>
            <a:off x="182509" y="6637907"/>
            <a:ext cx="109014" cy="6431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8" name="正方形/長方形 347"/>
          <p:cNvSpPr/>
          <p:nvPr/>
        </p:nvSpPr>
        <p:spPr>
          <a:xfrm rot="5400000">
            <a:off x="558584" y="6980251"/>
            <a:ext cx="109015" cy="6431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9" name="正方形/長方形 348"/>
          <p:cNvSpPr/>
          <p:nvPr/>
        </p:nvSpPr>
        <p:spPr>
          <a:xfrm>
            <a:off x="291523" y="6475829"/>
            <a:ext cx="773496" cy="771483"/>
          </a:xfrm>
          <a:prstGeom prst="rect">
            <a:avLst/>
          </a:prstGeom>
          <a:noFill/>
          <a:ln w="12700" cap="flat" cmpd="sng" algn="ctr">
            <a:solidFill>
              <a:srgbClr val="00009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0" name="テキスト ボックス 349"/>
          <p:cNvSpPr txBox="1"/>
          <p:nvPr/>
        </p:nvSpPr>
        <p:spPr>
          <a:xfrm>
            <a:off x="291523" y="699834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GC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51" name="テキスト ボックス 350"/>
          <p:cNvSpPr txBox="1"/>
          <p:nvPr/>
        </p:nvSpPr>
        <p:spPr>
          <a:xfrm>
            <a:off x="293700" y="659372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M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grpSp>
        <p:nvGrpSpPr>
          <p:cNvPr id="7" name="Group 1"/>
          <p:cNvGrpSpPr/>
          <p:nvPr/>
        </p:nvGrpSpPr>
        <p:grpSpPr>
          <a:xfrm>
            <a:off x="2635274" y="1612534"/>
            <a:ext cx="287999" cy="2555194"/>
            <a:chOff x="2661193" y="1651512"/>
            <a:chExt cx="288000" cy="2555194"/>
          </a:xfrm>
        </p:grpSpPr>
        <p:cxnSp>
          <p:nvCxnSpPr>
            <p:cNvPr id="155" name="Straight Connector 154"/>
            <p:cNvCxnSpPr/>
            <p:nvPr/>
          </p:nvCxnSpPr>
          <p:spPr>
            <a:xfrm>
              <a:off x="2877193" y="1651512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/>
            <p:nvPr/>
          </p:nvCxnSpPr>
          <p:spPr>
            <a:xfrm>
              <a:off x="2877193" y="2460016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/>
            <p:nvPr/>
          </p:nvCxnSpPr>
          <p:spPr>
            <a:xfrm>
              <a:off x="2661193" y="3398202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157"/>
            <p:cNvCxnSpPr/>
            <p:nvPr/>
          </p:nvCxnSpPr>
          <p:spPr>
            <a:xfrm>
              <a:off x="2661193" y="4206706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Group 159"/>
          <p:cNvGrpSpPr/>
          <p:nvPr/>
        </p:nvGrpSpPr>
        <p:grpSpPr>
          <a:xfrm>
            <a:off x="5374581" y="1612534"/>
            <a:ext cx="287999" cy="2555194"/>
            <a:chOff x="2661193" y="1651512"/>
            <a:chExt cx="288000" cy="2555194"/>
          </a:xfrm>
        </p:grpSpPr>
        <p:cxnSp>
          <p:nvCxnSpPr>
            <p:cNvPr id="161" name="Straight Connector 160"/>
            <p:cNvCxnSpPr/>
            <p:nvPr/>
          </p:nvCxnSpPr>
          <p:spPr>
            <a:xfrm>
              <a:off x="2877193" y="1651512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/>
            <p:cNvCxnSpPr/>
            <p:nvPr/>
          </p:nvCxnSpPr>
          <p:spPr>
            <a:xfrm>
              <a:off x="2877193" y="2460016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Straight Connector 162"/>
            <p:cNvCxnSpPr/>
            <p:nvPr/>
          </p:nvCxnSpPr>
          <p:spPr>
            <a:xfrm>
              <a:off x="2661193" y="3398202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/>
            <p:nvPr/>
          </p:nvCxnSpPr>
          <p:spPr>
            <a:xfrm>
              <a:off x="2661193" y="4206706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 164"/>
          <p:cNvGrpSpPr/>
          <p:nvPr/>
        </p:nvGrpSpPr>
        <p:grpSpPr>
          <a:xfrm>
            <a:off x="2635274" y="5462473"/>
            <a:ext cx="287999" cy="2555194"/>
            <a:chOff x="2661193" y="1651512"/>
            <a:chExt cx="288000" cy="2555194"/>
          </a:xfrm>
        </p:grpSpPr>
        <p:cxnSp>
          <p:nvCxnSpPr>
            <p:cNvPr id="166" name="Straight Connector 165"/>
            <p:cNvCxnSpPr/>
            <p:nvPr/>
          </p:nvCxnSpPr>
          <p:spPr>
            <a:xfrm>
              <a:off x="2877193" y="1651512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2877193" y="2460016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2661193" y="3398202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>
              <a:off x="2661193" y="4206706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Group 169"/>
          <p:cNvGrpSpPr/>
          <p:nvPr/>
        </p:nvGrpSpPr>
        <p:grpSpPr>
          <a:xfrm>
            <a:off x="5374581" y="5462473"/>
            <a:ext cx="287999" cy="2555194"/>
            <a:chOff x="2661193" y="1651512"/>
            <a:chExt cx="288000" cy="2555194"/>
          </a:xfrm>
        </p:grpSpPr>
        <p:cxnSp>
          <p:nvCxnSpPr>
            <p:cNvPr id="171" name="Straight Connector 170"/>
            <p:cNvCxnSpPr/>
            <p:nvPr/>
          </p:nvCxnSpPr>
          <p:spPr>
            <a:xfrm>
              <a:off x="2877193" y="1651512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/>
            <p:cNvCxnSpPr/>
            <p:nvPr/>
          </p:nvCxnSpPr>
          <p:spPr>
            <a:xfrm>
              <a:off x="2877193" y="2460016"/>
              <a:ext cx="72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/>
            <p:cNvCxnSpPr/>
            <p:nvPr/>
          </p:nvCxnSpPr>
          <p:spPr>
            <a:xfrm>
              <a:off x="2661193" y="3398202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/>
            <p:cNvCxnSpPr/>
            <p:nvPr/>
          </p:nvCxnSpPr>
          <p:spPr>
            <a:xfrm>
              <a:off x="2661193" y="4206706"/>
              <a:ext cx="288000" cy="0"/>
            </a:xfrm>
            <a:prstGeom prst="line">
              <a:avLst/>
            </a:prstGeom>
            <a:ln w="127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5" name="テキスト ボックス 164"/>
          <p:cNvSpPr txBox="1"/>
          <p:nvPr/>
        </p:nvSpPr>
        <p:spPr>
          <a:xfrm>
            <a:off x="194735" y="8325302"/>
            <a:ext cx="64799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2.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Drd1 </a:t>
            </a:r>
            <a:r>
              <a:rPr lang="en-US" altLang="ja-JP" sz="1200" b="1" i="1" dirty="0">
                <a:solidFill>
                  <a:srgbClr val="000000"/>
                </a:solidFill>
                <a:latin typeface="Times New Roman"/>
                <a:cs typeface="Times New Roman"/>
              </a:rPr>
              <a:t>promoter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-driven EGFP expression in cells at developmental stages of adult neurogenesis and mature granule cells in the dentate </a:t>
            </a:r>
            <a:r>
              <a:rPr lang="en-US" altLang="ja-JP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gyrus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just"/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entate gyrus slices from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[</a:t>
            </a:r>
            <a:r>
              <a:rPr lang="en-US" altLang="ja-JP" sz="1200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Drd1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]-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GFP mice treated with the fluoxetine (FLX; 15 mg/kg/day for 14 days) or placebo (PL) pellet were immunostained with antibodies for markers of different developmental stages of adult neurogenesis: Ki-67, doublecortin, calretinin and NeuN. ML, molecular layer; GC, granule cell layer; H,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hilu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. Scale bars, 100 µm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149</Words>
  <Application>Microsoft Macintosh PowerPoint</Application>
  <PresentationFormat>A4 210x297 mm</PresentationFormat>
  <Paragraphs>4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28:47Z</dcterms:modified>
  <cp:category/>
</cp:coreProperties>
</file>